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556" r:id="rId2"/>
    <p:sldId id="558" r:id="rId3"/>
    <p:sldId id="557" r:id="rId4"/>
    <p:sldId id="260" r:id="rId5"/>
    <p:sldId id="257" r:id="rId6"/>
    <p:sldId id="267" r:id="rId7"/>
    <p:sldId id="266" r:id="rId8"/>
    <p:sldId id="259" r:id="rId9"/>
  </p:sldIdLst>
  <p:sldSz cx="9144000" cy="6858000" type="lett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64A2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7265A7A-C36B-4D75-8C1C-9B6C28156576}" v="13" dt="2023-07-20T19:08:31.5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bramaniam, Rajagopal (AAFC/AAC)" userId="e58e1ad2-09ef-48bd-9578-01ab189f9de9" providerId="ADAL" clId="{D7265A7A-C36B-4D75-8C1C-9B6C28156576}"/>
    <pc:docChg chg="undo custSel addSld delSld modSld">
      <pc:chgData name="Subramaniam, Rajagopal (AAFC/AAC)" userId="e58e1ad2-09ef-48bd-9578-01ab189f9de9" providerId="ADAL" clId="{D7265A7A-C36B-4D75-8C1C-9B6C28156576}" dt="2023-08-01T14:00:48.856" v="166" actId="20577"/>
      <pc:docMkLst>
        <pc:docMk/>
      </pc:docMkLst>
      <pc:sldChg chg="modSp mod">
        <pc:chgData name="Subramaniam, Rajagopal (AAFC/AAC)" userId="e58e1ad2-09ef-48bd-9578-01ab189f9de9" providerId="ADAL" clId="{D7265A7A-C36B-4D75-8C1C-9B6C28156576}" dt="2023-07-18T14:16:56.596" v="1" actId="20577"/>
        <pc:sldMkLst>
          <pc:docMk/>
          <pc:sldMk cId="1375837154" sldId="260"/>
        </pc:sldMkLst>
        <pc:spChg chg="mod">
          <ac:chgData name="Subramaniam, Rajagopal (AAFC/AAC)" userId="e58e1ad2-09ef-48bd-9578-01ab189f9de9" providerId="ADAL" clId="{D7265A7A-C36B-4D75-8C1C-9B6C28156576}" dt="2023-07-18T14:16:56.596" v="1" actId="20577"/>
          <ac:spMkLst>
            <pc:docMk/>
            <pc:sldMk cId="1375837154" sldId="260"/>
            <ac:spMk id="3" creationId="{4DED8452-7406-DA5C-8B9A-8B7E30BA40F1}"/>
          </ac:spMkLst>
        </pc:spChg>
      </pc:sldChg>
      <pc:sldChg chg="modSp mod">
        <pc:chgData name="Subramaniam, Rajagopal (AAFC/AAC)" userId="e58e1ad2-09ef-48bd-9578-01ab189f9de9" providerId="ADAL" clId="{D7265A7A-C36B-4D75-8C1C-9B6C28156576}" dt="2023-08-01T14:00:48.856" v="166" actId="20577"/>
        <pc:sldMkLst>
          <pc:docMk/>
          <pc:sldMk cId="3792113882" sldId="267"/>
        </pc:sldMkLst>
        <pc:spChg chg="mod">
          <ac:chgData name="Subramaniam, Rajagopal (AAFC/AAC)" userId="e58e1ad2-09ef-48bd-9578-01ab189f9de9" providerId="ADAL" clId="{D7265A7A-C36B-4D75-8C1C-9B6C28156576}" dt="2023-08-01T14:00:48.856" v="166" actId="20577"/>
          <ac:spMkLst>
            <pc:docMk/>
            <pc:sldMk cId="3792113882" sldId="267"/>
            <ac:spMk id="3" creationId="{32CD74B5-3008-F1B0-121C-D55D19615EBF}"/>
          </ac:spMkLst>
        </pc:spChg>
      </pc:sldChg>
      <pc:sldChg chg="modSp mod">
        <pc:chgData name="Subramaniam, Rajagopal (AAFC/AAC)" userId="e58e1ad2-09ef-48bd-9578-01ab189f9de9" providerId="ADAL" clId="{D7265A7A-C36B-4D75-8C1C-9B6C28156576}" dt="2023-08-01T13:57:38.374" v="165" actId="1076"/>
        <pc:sldMkLst>
          <pc:docMk/>
          <pc:sldMk cId="4123559914" sldId="556"/>
        </pc:sldMkLst>
        <pc:spChg chg="mod">
          <ac:chgData name="Subramaniam, Rajagopal (AAFC/AAC)" userId="e58e1ad2-09ef-48bd-9578-01ab189f9de9" providerId="ADAL" clId="{D7265A7A-C36B-4D75-8C1C-9B6C28156576}" dt="2023-08-01T13:57:38.374" v="165" actId="1076"/>
          <ac:spMkLst>
            <pc:docMk/>
            <pc:sldMk cId="4123559914" sldId="556"/>
            <ac:spMk id="7" creationId="{84029758-A6AB-8AE4-366B-AD3AF4516171}"/>
          </ac:spMkLst>
        </pc:spChg>
      </pc:sldChg>
      <pc:sldChg chg="addSp delSp modSp mod">
        <pc:chgData name="Subramaniam, Rajagopal (AAFC/AAC)" userId="e58e1ad2-09ef-48bd-9578-01ab189f9de9" providerId="ADAL" clId="{D7265A7A-C36B-4D75-8C1C-9B6C28156576}" dt="2023-07-20T19:08:44.091" v="162" actId="1076"/>
        <pc:sldMkLst>
          <pc:docMk/>
          <pc:sldMk cId="2357444036" sldId="557"/>
        </pc:sldMkLst>
        <pc:spChg chg="add del mod">
          <ac:chgData name="Subramaniam, Rajagopal (AAFC/AAC)" userId="e58e1ad2-09ef-48bd-9578-01ab189f9de9" providerId="ADAL" clId="{D7265A7A-C36B-4D75-8C1C-9B6C28156576}" dt="2023-07-20T19:08:30.195" v="156" actId="478"/>
          <ac:spMkLst>
            <pc:docMk/>
            <pc:sldMk cId="2357444036" sldId="557"/>
            <ac:spMk id="2" creationId="{52B09C75-0016-1651-C4C3-26EFFAB350E7}"/>
          </ac:spMkLst>
        </pc:spChg>
        <pc:spChg chg="add del mod">
          <ac:chgData name="Subramaniam, Rajagopal (AAFC/AAC)" userId="e58e1ad2-09ef-48bd-9578-01ab189f9de9" providerId="ADAL" clId="{D7265A7A-C36B-4D75-8C1C-9B6C28156576}" dt="2023-07-20T19:08:30.195" v="156" actId="478"/>
          <ac:spMkLst>
            <pc:docMk/>
            <pc:sldMk cId="2357444036" sldId="557"/>
            <ac:spMk id="8" creationId="{29C21D38-2E87-DD4F-BFDF-435CDC39B7D7}"/>
          </ac:spMkLst>
        </pc:spChg>
        <pc:picChg chg="del">
          <ac:chgData name="Subramaniam, Rajagopal (AAFC/AAC)" userId="e58e1ad2-09ef-48bd-9578-01ab189f9de9" providerId="ADAL" clId="{D7265A7A-C36B-4D75-8C1C-9B6C28156576}" dt="2023-07-20T19:08:27.635" v="155" actId="478"/>
          <ac:picMkLst>
            <pc:docMk/>
            <pc:sldMk cId="2357444036" sldId="557"/>
            <ac:picMk id="6" creationId="{C452BA9C-7C00-B16E-3435-7AFAAE9E32D4}"/>
          </ac:picMkLst>
        </pc:picChg>
        <pc:picChg chg="add mod">
          <ac:chgData name="Subramaniam, Rajagopal (AAFC/AAC)" userId="e58e1ad2-09ef-48bd-9578-01ab189f9de9" providerId="ADAL" clId="{D7265A7A-C36B-4D75-8C1C-9B6C28156576}" dt="2023-07-20T19:08:44.091" v="162" actId="1076"/>
          <ac:picMkLst>
            <pc:docMk/>
            <pc:sldMk cId="2357444036" sldId="557"/>
            <ac:picMk id="9" creationId="{AA4B9F78-AB0F-0FC4-509E-F9BF36FC677F}"/>
          </ac:picMkLst>
        </pc:picChg>
      </pc:sldChg>
      <pc:sldChg chg="addSp delSp modSp add del mod">
        <pc:chgData name="Subramaniam, Rajagopal (AAFC/AAC)" userId="e58e1ad2-09ef-48bd-9578-01ab189f9de9" providerId="ADAL" clId="{D7265A7A-C36B-4D75-8C1C-9B6C28156576}" dt="2023-07-20T19:08:51.555" v="163" actId="47"/>
        <pc:sldMkLst>
          <pc:docMk/>
          <pc:sldMk cId="2426283194" sldId="559"/>
        </pc:sldMkLst>
        <pc:spChg chg="mod">
          <ac:chgData name="Subramaniam, Rajagopal (AAFC/AAC)" userId="e58e1ad2-09ef-48bd-9578-01ab189f9de9" providerId="ADAL" clId="{D7265A7A-C36B-4D75-8C1C-9B6C28156576}" dt="2023-07-20T19:05:51.936" v="137" actId="164"/>
          <ac:spMkLst>
            <pc:docMk/>
            <pc:sldMk cId="2426283194" sldId="559"/>
            <ac:spMk id="2" creationId="{52B09C75-0016-1651-C4C3-26EFFAB350E7}"/>
          </ac:spMkLst>
        </pc:spChg>
        <pc:spChg chg="del">
          <ac:chgData name="Subramaniam, Rajagopal (AAFC/AAC)" userId="e58e1ad2-09ef-48bd-9578-01ab189f9de9" providerId="ADAL" clId="{D7265A7A-C36B-4D75-8C1C-9B6C28156576}" dt="2023-07-20T19:01:51.687" v="39" actId="478"/>
          <ac:spMkLst>
            <pc:docMk/>
            <pc:sldMk cId="2426283194" sldId="559"/>
            <ac:spMk id="4" creationId="{5CEBBAD2-27C2-91BD-0C6E-E8380F2ACF00}"/>
          </ac:spMkLst>
        </pc:spChg>
        <pc:spChg chg="del mod">
          <ac:chgData name="Subramaniam, Rajagopal (AAFC/AAC)" userId="e58e1ad2-09ef-48bd-9578-01ab189f9de9" providerId="ADAL" clId="{D7265A7A-C36B-4D75-8C1C-9B6C28156576}" dt="2023-07-20T19:01:39.591" v="36" actId="478"/>
          <ac:spMkLst>
            <pc:docMk/>
            <pc:sldMk cId="2426283194" sldId="559"/>
            <ac:spMk id="5" creationId="{90134624-DB7A-39D7-B3A2-1456EF12F917}"/>
          </ac:spMkLst>
        </pc:spChg>
        <pc:spChg chg="del mod">
          <ac:chgData name="Subramaniam, Rajagopal (AAFC/AAC)" userId="e58e1ad2-09ef-48bd-9578-01ab189f9de9" providerId="ADAL" clId="{D7265A7A-C36B-4D75-8C1C-9B6C28156576}" dt="2023-07-20T19:01:48.775" v="38" actId="478"/>
          <ac:spMkLst>
            <pc:docMk/>
            <pc:sldMk cId="2426283194" sldId="559"/>
            <ac:spMk id="7" creationId="{AA67307D-8F29-53BF-B225-E2176EE6A6AF}"/>
          </ac:spMkLst>
        </pc:spChg>
        <pc:spChg chg="mod">
          <ac:chgData name="Subramaniam, Rajagopal (AAFC/AAC)" userId="e58e1ad2-09ef-48bd-9578-01ab189f9de9" providerId="ADAL" clId="{D7265A7A-C36B-4D75-8C1C-9B6C28156576}" dt="2023-07-20T19:05:51.936" v="137" actId="164"/>
          <ac:spMkLst>
            <pc:docMk/>
            <pc:sldMk cId="2426283194" sldId="559"/>
            <ac:spMk id="8" creationId="{29C21D38-2E87-DD4F-BFDF-435CDC39B7D7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9" creationId="{8DEA24DF-3BFE-B310-D242-9F631CD61A92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10" creationId="{A048F746-5259-08DC-EA1D-D2D23D4D99EB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11" creationId="{F749D14B-1B9E-5858-A25A-91AF79D313D7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12" creationId="{16C817FF-DEEB-128B-024E-93B3D59A67EE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13" creationId="{18F7109B-1D4A-8325-5347-7529BA6BDA59}"/>
          </ac:spMkLst>
        </pc:spChg>
        <pc:spChg chg="add mod">
          <ac:chgData name="Subramaniam, Rajagopal (AAFC/AAC)" userId="e58e1ad2-09ef-48bd-9578-01ab189f9de9" providerId="ADAL" clId="{D7265A7A-C36B-4D75-8C1C-9B6C28156576}" dt="2023-07-20T19:05:45.152" v="136" actId="164"/>
          <ac:spMkLst>
            <pc:docMk/>
            <pc:sldMk cId="2426283194" sldId="559"/>
            <ac:spMk id="14" creationId="{0DE61A20-0ECF-F274-F24A-4F309772147A}"/>
          </ac:spMkLst>
        </pc:spChg>
        <pc:spChg chg="add mod">
          <ac:chgData name="Subramaniam, Rajagopal (AAFC/AAC)" userId="e58e1ad2-09ef-48bd-9578-01ab189f9de9" providerId="ADAL" clId="{D7265A7A-C36B-4D75-8C1C-9B6C28156576}" dt="2023-07-20T19:08:22.401" v="154" actId="164"/>
          <ac:spMkLst>
            <pc:docMk/>
            <pc:sldMk cId="2426283194" sldId="559"/>
            <ac:spMk id="17" creationId="{2C62E943-D4C9-BC66-2065-95CEA8AC1E42}"/>
          </ac:spMkLst>
        </pc:spChg>
        <pc:grpChg chg="add mod">
          <ac:chgData name="Subramaniam, Rajagopal (AAFC/AAC)" userId="e58e1ad2-09ef-48bd-9578-01ab189f9de9" providerId="ADAL" clId="{D7265A7A-C36B-4D75-8C1C-9B6C28156576}" dt="2023-07-20T19:05:51.936" v="137" actId="164"/>
          <ac:grpSpMkLst>
            <pc:docMk/>
            <pc:sldMk cId="2426283194" sldId="559"/>
            <ac:grpSpMk id="15" creationId="{EFC98A88-777C-1964-710C-8AA9E53695BA}"/>
          </ac:grpSpMkLst>
        </pc:grpChg>
        <pc:grpChg chg="add mod">
          <ac:chgData name="Subramaniam, Rajagopal (AAFC/AAC)" userId="e58e1ad2-09ef-48bd-9578-01ab189f9de9" providerId="ADAL" clId="{D7265A7A-C36B-4D75-8C1C-9B6C28156576}" dt="2023-07-20T19:08:22.401" v="154" actId="164"/>
          <ac:grpSpMkLst>
            <pc:docMk/>
            <pc:sldMk cId="2426283194" sldId="559"/>
            <ac:grpSpMk id="16" creationId="{7014B07C-52E5-7C60-C31F-3645417726D4}"/>
          </ac:grpSpMkLst>
        </pc:grpChg>
        <pc:grpChg chg="add mod">
          <ac:chgData name="Subramaniam, Rajagopal (AAFC/AAC)" userId="e58e1ad2-09ef-48bd-9578-01ab189f9de9" providerId="ADAL" clId="{D7265A7A-C36B-4D75-8C1C-9B6C28156576}" dt="2023-07-20T19:08:22.401" v="154" actId="164"/>
          <ac:grpSpMkLst>
            <pc:docMk/>
            <pc:sldMk cId="2426283194" sldId="559"/>
            <ac:grpSpMk id="18" creationId="{E8A31F42-9E8F-56AF-F0C6-3195EA686625}"/>
          </ac:grpSpMkLst>
        </pc:grpChg>
        <pc:picChg chg="del">
          <ac:chgData name="Subramaniam, Rajagopal (AAFC/AAC)" userId="e58e1ad2-09ef-48bd-9578-01ab189f9de9" providerId="ADAL" clId="{D7265A7A-C36B-4D75-8C1C-9B6C28156576}" dt="2023-07-20T19:01:34.240" v="34" actId="478"/>
          <ac:picMkLst>
            <pc:docMk/>
            <pc:sldMk cId="2426283194" sldId="559"/>
            <ac:picMk id="3" creationId="{10192A76-A8AD-BE53-B961-0A8966E7AA2D}"/>
          </ac:picMkLst>
        </pc:picChg>
        <pc:picChg chg="mod modCrop">
          <ac:chgData name="Subramaniam, Rajagopal (AAFC/AAC)" userId="e58e1ad2-09ef-48bd-9578-01ab189f9de9" providerId="ADAL" clId="{D7265A7A-C36B-4D75-8C1C-9B6C28156576}" dt="2023-07-20T19:05:51.936" v="137" actId="164"/>
          <ac:picMkLst>
            <pc:docMk/>
            <pc:sldMk cId="2426283194" sldId="559"/>
            <ac:picMk id="6" creationId="{C452BA9C-7C00-B16E-3435-7AFAAE9E32D4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2.bin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3.bin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Letemci01-cifs.efs.agr.gc.ca\common\Group_Shares\SWheatLab\Dianevys\Dianevys%20thesis%20figures\Figure%202.13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Letemci01-cifs.efs.agr.gc.ca\common\Group_Shares\SWheatLab\Dianevys\paper%20Mgv1\Figure%202.8%20for%20Mgv1%20paper_confidence%20levels%20and%20SPS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Letemci01-cifs.efs.agr.gc.ca\common\Group_Shares\SWheatLab\Dianevys\paper%20Mgv1\Figure%202.8%20for%20Mgv1%20paper_confidence%20levels%20and%20SPS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430302813928729"/>
          <c:y val="0.11327964654593703"/>
          <c:w val="0.63035738764416205"/>
          <c:h val="0.69626179266957422"/>
        </c:manualLayout>
      </c:layout>
      <c:lineChart>
        <c:grouping val="standard"/>
        <c:varyColors val="0"/>
        <c:ser>
          <c:idx val="0"/>
          <c:order val="0"/>
          <c:tx>
            <c:v>MGV1OX1</c:v>
          </c:tx>
          <c:spPr>
            <a:ln w="12700">
              <a:solidFill>
                <a:schemeClr val="accent6"/>
              </a:solidFill>
            </a:ln>
          </c:spPr>
          <c:marker>
            <c:symbol val="diamond"/>
            <c:size val="3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 2.5.xlsx]Sheet1'!$I$12,'[Figure 2.5.xlsx]Sheet1'!$L$12,'[Figure 2.5.xlsx]Sheet1'!$O$12,'[Figure 2.5.xlsx]Sheet1'!$R$12</c:f>
                <c:numCache>
                  <c:formatCode>General</c:formatCode>
                  <c:ptCount val="4"/>
                  <c:pt idx="0">
                    <c:v>0.22025276306681088</c:v>
                  </c:pt>
                  <c:pt idx="1">
                    <c:v>0.22025276306681088</c:v>
                  </c:pt>
                  <c:pt idx="2">
                    <c:v>0.22940603386794925</c:v>
                  </c:pt>
                  <c:pt idx="3">
                    <c:v>0.13354903415843652</c:v>
                  </c:pt>
                </c:numCache>
              </c:numRef>
            </c:plus>
            <c:minus>
              <c:numRef>
                <c:f>'[Figure 2.5.xlsx]Sheet1'!$I$12,'[Figure 2.5.xlsx]Sheet1'!$L$12,'[Figure 2.5.xlsx]Sheet1'!$O$12,'[Figure 2.5.xlsx]Sheet1'!$R$12</c:f>
                <c:numCache>
                  <c:formatCode>General</c:formatCode>
                  <c:ptCount val="4"/>
                  <c:pt idx="0">
                    <c:v>0.22025276306681088</c:v>
                  </c:pt>
                  <c:pt idx="1">
                    <c:v>0.22025276306681088</c:v>
                  </c:pt>
                  <c:pt idx="2">
                    <c:v>0.22940603386794925</c:v>
                  </c:pt>
                  <c:pt idx="3">
                    <c:v>0.13354903415843652</c:v>
                  </c:pt>
                </c:numCache>
              </c:numRef>
            </c:minus>
            <c:spPr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c:spPr>
          </c:errBars>
          <c:val>
            <c:numRef>
              <c:f>'[Figure 2.5.xlsx]Sheet1'!$G$12,'[Figure 2.5.xlsx]Sheet1'!$J$12,'[Figure 2.5.xlsx]Sheet1'!$M$12,'[Figure 2.5.xlsx]Sheet1'!$P$12</c:f>
              <c:numCache>
                <c:formatCode>0.0</c:formatCode>
                <c:ptCount val="4"/>
                <c:pt idx="0">
                  <c:v>2.5000000000000004</c:v>
                </c:pt>
                <c:pt idx="1">
                  <c:v>4.3562500000000002</c:v>
                </c:pt>
                <c:pt idx="2">
                  <c:v>6.6437500000000007</c:v>
                </c:pt>
                <c:pt idx="3">
                  <c:v>8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7B9-4E54-BCFE-50CCBE6D6314}"/>
            </c:ext>
          </c:extLst>
        </c:ser>
        <c:ser>
          <c:idx val="1"/>
          <c:order val="1"/>
          <c:tx>
            <c:v>MGV1OX2</c:v>
          </c:tx>
          <c:spPr>
            <a:ln w="12700">
              <a:solidFill>
                <a:schemeClr val="accent2"/>
              </a:solidFill>
            </a:ln>
          </c:spPr>
          <c:marker>
            <c:symbol val="x"/>
            <c:size val="4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 2.5.xlsx]Sheet1'!$I$20,'[Figure 2.5.xlsx]Sheet1'!$L$20,'[Figure 2.5.xlsx]Sheet1'!$O$20,'[Figure 2.5.xlsx]Sheet1'!$R$20</c:f>
                <c:numCache>
                  <c:formatCode>General</c:formatCode>
                  <c:ptCount val="4"/>
                  <c:pt idx="0">
                    <c:v>0.20865752422413303</c:v>
                  </c:pt>
                  <c:pt idx="1">
                    <c:v>0.20865752422413303</c:v>
                  </c:pt>
                  <c:pt idx="2">
                    <c:v>0.23676360007837158</c:v>
                  </c:pt>
                  <c:pt idx="3">
                    <c:v>0.1434546746616851</c:v>
                  </c:pt>
                </c:numCache>
              </c:numRef>
            </c:plus>
            <c:minus>
              <c:numRef>
                <c:f>'[Figure 2.5.xlsx]Sheet1'!$I$20,'[Figure 2.5.xlsx]Sheet1'!$L$20,'[Figure 2.5.xlsx]Sheet1'!$O$20,'[Figure 2.5.xlsx]Sheet1'!$R$20</c:f>
                <c:numCache>
                  <c:formatCode>General</c:formatCode>
                  <c:ptCount val="4"/>
                  <c:pt idx="0">
                    <c:v>0.20865752422413303</c:v>
                  </c:pt>
                  <c:pt idx="1">
                    <c:v>0.20865752422413303</c:v>
                  </c:pt>
                  <c:pt idx="2">
                    <c:v>0.23676360007837158</c:v>
                  </c:pt>
                  <c:pt idx="3">
                    <c:v>0.1434546746616851</c:v>
                  </c:pt>
                </c:numCache>
              </c:numRef>
            </c:minus>
            <c:spPr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c:spPr>
          </c:errBars>
          <c:val>
            <c:numRef>
              <c:f>'[Figure 2.5.xlsx]Sheet1'!$G$20,'[Figure 2.5.xlsx]Sheet1'!$J$20,'[Figure 2.5.xlsx]Sheet1'!$M$20,'[Figure 2.5.xlsx]Sheet1'!$P$20</c:f>
              <c:numCache>
                <c:formatCode>0.0</c:formatCode>
                <c:ptCount val="4"/>
                <c:pt idx="0">
                  <c:v>2.6062499999999997</c:v>
                </c:pt>
                <c:pt idx="1">
                  <c:v>4.5187499999999998</c:v>
                </c:pt>
                <c:pt idx="2">
                  <c:v>6.8062500000000004</c:v>
                </c:pt>
                <c:pt idx="3">
                  <c:v>8.224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7B9-4E54-BCFE-50CCBE6D6314}"/>
            </c:ext>
          </c:extLst>
        </c:ser>
        <c:ser>
          <c:idx val="2"/>
          <c:order val="2"/>
          <c:tx>
            <c:v>MGV1OX6</c:v>
          </c:tx>
          <c:spPr>
            <a:ln w="12700">
              <a:solidFill>
                <a:schemeClr val="accent5"/>
              </a:solidFill>
            </a:ln>
          </c:spPr>
          <c:marker>
            <c:symbol val="circle"/>
            <c:size val="2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 2.5.xlsx]Sheet1'!$I$28,'[Figure 2.5.xlsx]Sheet1'!$L$28,'[Figure 2.5.xlsx]Sheet1'!$O$28,'[Figure 2.5.xlsx]Sheet1'!$R$28</c:f>
                <c:numCache>
                  <c:formatCode>General</c:formatCode>
                  <c:ptCount val="4"/>
                  <c:pt idx="0">
                    <c:v>9.7559726337557384E-2</c:v>
                  </c:pt>
                  <c:pt idx="1">
                    <c:v>9.7559726337557384E-2</c:v>
                  </c:pt>
                  <c:pt idx="2">
                    <c:v>0.11822324785854067</c:v>
                  </c:pt>
                  <c:pt idx="3">
                    <c:v>0.12552284032897457</c:v>
                  </c:pt>
                </c:numCache>
              </c:numRef>
            </c:plus>
            <c:minus>
              <c:numRef>
                <c:f>'[Figure 2.5.xlsx]Sheet1'!$I$28,'[Figure 2.5.xlsx]Sheet1'!$L$28,'[Figure 2.5.xlsx]Sheet1'!$O$28,'[Figure 2.5.xlsx]Sheet1'!$R$28</c:f>
                <c:numCache>
                  <c:formatCode>General</c:formatCode>
                  <c:ptCount val="4"/>
                  <c:pt idx="0">
                    <c:v>9.7559726337557384E-2</c:v>
                  </c:pt>
                  <c:pt idx="1">
                    <c:v>9.7559726337557384E-2</c:v>
                  </c:pt>
                  <c:pt idx="2">
                    <c:v>0.11822324785854067</c:v>
                  </c:pt>
                  <c:pt idx="3">
                    <c:v>0.12552284032897457</c:v>
                  </c:pt>
                </c:numCache>
              </c:numRef>
            </c:minus>
            <c:spPr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c:spPr>
          </c:errBars>
          <c:val>
            <c:numRef>
              <c:f>'[Figure 2.5.xlsx]Sheet1'!$G$28,'[Figure 2.5.xlsx]Sheet1'!$J$28,'[Figure 2.5.xlsx]Sheet1'!$M$28,'[Figure 2.5.xlsx]Sheet1'!$P$28</c:f>
              <c:numCache>
                <c:formatCode>0.0</c:formatCode>
                <c:ptCount val="4"/>
                <c:pt idx="0">
                  <c:v>2.6124999999999998</c:v>
                </c:pt>
                <c:pt idx="1">
                  <c:v>4.5124999999999993</c:v>
                </c:pt>
                <c:pt idx="2">
                  <c:v>6.8125</c:v>
                </c:pt>
                <c:pt idx="3">
                  <c:v>8.23124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7B9-4E54-BCFE-50CCBE6D6314}"/>
            </c:ext>
          </c:extLst>
        </c:ser>
        <c:ser>
          <c:idx val="3"/>
          <c:order val="3"/>
          <c:tx>
            <c:v>MGV1OX8</c:v>
          </c:tx>
          <c:spPr>
            <a:ln w="12700">
              <a:solidFill>
                <a:schemeClr val="accent4"/>
              </a:solidFill>
            </a:ln>
          </c:spPr>
          <c:marker>
            <c:symbol val="triangle"/>
            <c:size val="3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 2.5.xlsx]Sheet1'!$I$36,'[Figure 2.5.xlsx]Sheet1'!$L$36,'[Figure 2.5.xlsx]Sheet1'!$O$36,'[Figure 2.5.xlsx]Sheet1'!$R$36</c:f>
                <c:numCache>
                  <c:formatCode>General</c:formatCode>
                  <c:ptCount val="4"/>
                  <c:pt idx="0">
                    <c:v>0.12275996356648029</c:v>
                  </c:pt>
                  <c:pt idx="1">
                    <c:v>0.12275996356648029</c:v>
                  </c:pt>
                  <c:pt idx="2">
                    <c:v>0.11073300935447281</c:v>
                  </c:pt>
                  <c:pt idx="3">
                    <c:v>0.12388981359676525</c:v>
                  </c:pt>
                </c:numCache>
              </c:numRef>
            </c:plus>
            <c:minus>
              <c:numRef>
                <c:f>'[Figure 2.5.xlsx]Sheet1'!$I$36,'[Figure 2.5.xlsx]Sheet1'!$L$36,'[Figure 2.5.xlsx]Sheet1'!$O$36,'[Figure 2.5.xlsx]Sheet1'!$R$36</c:f>
                <c:numCache>
                  <c:formatCode>General</c:formatCode>
                  <c:ptCount val="4"/>
                  <c:pt idx="0">
                    <c:v>0.12275996356648029</c:v>
                  </c:pt>
                  <c:pt idx="1">
                    <c:v>0.12275996356648029</c:v>
                  </c:pt>
                  <c:pt idx="2">
                    <c:v>0.11073300935447281</c:v>
                  </c:pt>
                  <c:pt idx="3">
                    <c:v>0.12388981359676525</c:v>
                  </c:pt>
                </c:numCache>
              </c:numRef>
            </c:minus>
            <c:spPr>
              <a:ln>
                <a:solidFill>
                  <a:schemeClr val="accent4">
                    <a:lumMod val="60000"/>
                    <a:lumOff val="40000"/>
                  </a:schemeClr>
                </a:solidFill>
              </a:ln>
            </c:spPr>
          </c:errBars>
          <c:val>
            <c:numRef>
              <c:f>'[Figure 2.5.xlsx]Sheet1'!$G$36,'[Figure 2.5.xlsx]Sheet1'!$J$36,'[Figure 2.5.xlsx]Sheet1'!$M$36,'[Figure 2.5.xlsx]Sheet1'!$P$36</c:f>
              <c:numCache>
                <c:formatCode>0.0</c:formatCode>
                <c:ptCount val="4"/>
                <c:pt idx="0">
                  <c:v>2.7750000000000004</c:v>
                </c:pt>
                <c:pt idx="1">
                  <c:v>4.7312499999999993</c:v>
                </c:pt>
                <c:pt idx="2">
                  <c:v>7.0374999999999996</c:v>
                </c:pt>
                <c:pt idx="3">
                  <c:v>8.38749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7B9-4E54-BCFE-50CCBE6D6314}"/>
            </c:ext>
          </c:extLst>
        </c:ser>
        <c:ser>
          <c:idx val="4"/>
          <c:order val="4"/>
          <c:tx>
            <c:v>WT</c:v>
          </c:tx>
          <c:spPr>
            <a:ln w="12700">
              <a:solidFill>
                <a:schemeClr val="tx1"/>
              </a:solidFill>
            </a:ln>
          </c:spPr>
          <c:marker>
            <c:symbol val="x"/>
            <c:size val="3"/>
            <c:spPr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Figure 2.5.xlsx]Sheet1'!$I$44,'[Figure 2.5.xlsx]Sheet1'!$L$44,'[Figure 2.5.xlsx]Sheet1'!$O$44,'[Figure 2.5.xlsx]Sheet1'!$R$44</c:f>
                <c:numCache>
                  <c:formatCode>General</c:formatCode>
                  <c:ptCount val="4"/>
                  <c:pt idx="0">
                    <c:v>0.11858534134916562</c:v>
                  </c:pt>
                  <c:pt idx="1">
                    <c:v>0.11858534134916562</c:v>
                  </c:pt>
                  <c:pt idx="2">
                    <c:v>0.12135493916663929</c:v>
                  </c:pt>
                  <c:pt idx="3">
                    <c:v>0.10269791812482651</c:v>
                  </c:pt>
                </c:numCache>
              </c:numRef>
            </c:plus>
            <c:minus>
              <c:numRef>
                <c:f>'[Figure 2.5.xlsx]Sheet1'!$I$44,'[Figure 2.5.xlsx]Sheet1'!$L$44,'[Figure 2.5.xlsx]Sheet1'!$O$44,'[Figure 2.5.xlsx]Sheet1'!$R$44</c:f>
                <c:numCache>
                  <c:formatCode>General</c:formatCode>
                  <c:ptCount val="4"/>
                  <c:pt idx="0">
                    <c:v>0.11858534134916562</c:v>
                  </c:pt>
                  <c:pt idx="1">
                    <c:v>0.11858534134916562</c:v>
                  </c:pt>
                  <c:pt idx="2">
                    <c:v>0.12135493916663929</c:v>
                  </c:pt>
                  <c:pt idx="3">
                    <c:v>0.10269791812482651</c:v>
                  </c:pt>
                </c:numCache>
              </c:numRef>
            </c:minus>
            <c:spPr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errBars>
          <c:val>
            <c:numRef>
              <c:f>'[Figure 2.5.xlsx]Sheet1'!$G$44,'[Figure 2.5.xlsx]Sheet1'!$J$44,'[Figure 2.5.xlsx]Sheet1'!$M$44,'[Figure 2.5.xlsx]Sheet1'!$P$44</c:f>
              <c:numCache>
                <c:formatCode>0.0</c:formatCode>
                <c:ptCount val="4"/>
                <c:pt idx="0">
                  <c:v>2.4437499999999996</c:v>
                </c:pt>
                <c:pt idx="1">
                  <c:v>4.375</c:v>
                </c:pt>
                <c:pt idx="2">
                  <c:v>6.7312500000000002</c:v>
                </c:pt>
                <c:pt idx="3">
                  <c:v>8.18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27B9-4E54-BCFE-50CCBE6D63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314048"/>
        <c:axId val="93848704"/>
      </c:lineChart>
      <c:catAx>
        <c:axId val="933140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/>
                  <a:t>Days after inoculation</a:t>
                </a:r>
                <a:r>
                  <a:rPr lang="en-US" sz="1000" baseline="0"/>
                  <a:t> </a:t>
                </a:r>
                <a:endParaRPr lang="en-US" sz="1000"/>
              </a:p>
            </c:rich>
          </c:tx>
          <c:overlay val="0"/>
        </c:title>
        <c:majorTickMark val="out"/>
        <c:minorTickMark val="none"/>
        <c:tickLblPos val="nextTo"/>
        <c:crossAx val="93848704"/>
        <c:crosses val="autoZero"/>
        <c:auto val="1"/>
        <c:lblAlgn val="ctr"/>
        <c:lblOffset val="100"/>
        <c:noMultiLvlLbl val="0"/>
      </c:catAx>
      <c:valAx>
        <c:axId val="93848704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Colony Diameter (cm)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crossAx val="93314048"/>
        <c:crosses val="autoZero"/>
        <c:crossBetween val="between"/>
        <c:majorUnit val="2"/>
        <c:minorUnit val="1"/>
      </c:valAx>
    </c:plotArea>
    <c:legend>
      <c:legendPos val="t"/>
      <c:legendEntry>
        <c:idx val="0"/>
        <c:txPr>
          <a:bodyPr/>
          <a:lstStyle/>
          <a:p>
            <a:pPr>
              <a:defRPr sz="900" i="1"/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sz="900" i="1"/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sz="900" i="1"/>
            </a:pPr>
            <a:endParaRPr lang="en-US"/>
          </a:p>
        </c:txPr>
      </c:legendEntry>
      <c:legendEntry>
        <c:idx val="3"/>
        <c:txPr>
          <a:bodyPr/>
          <a:lstStyle/>
          <a:p>
            <a:pPr>
              <a:defRPr sz="900" i="1"/>
            </a:pPr>
            <a:endParaRPr lang="en-US"/>
          </a:p>
        </c:txPr>
      </c:legendEntry>
      <c:layout>
        <c:manualLayout>
          <c:xMode val="edge"/>
          <c:yMode val="edge"/>
          <c:x val="0.7348154639023704"/>
          <c:y val="0.23595491850268652"/>
          <c:w val="0.26185059160026675"/>
          <c:h val="0.38501036121824211"/>
        </c:manualLayout>
      </c:layout>
      <c:overlay val="0"/>
      <c:txPr>
        <a:bodyPr/>
        <a:lstStyle/>
        <a:p>
          <a:pPr>
            <a:defRPr sz="900"/>
          </a:pPr>
          <a:endParaRPr lang="en-US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D$14,'[Figure 2.6.xlsx]Sheet1'!$D$26,'[Figure 2.6.xlsx]Sheet1'!$D$38</c:f>
                <c:numCache>
                  <c:formatCode>General</c:formatCode>
                  <c:ptCount val="3"/>
                  <c:pt idx="0">
                    <c:v>2.5253813613805267</c:v>
                  </c:pt>
                  <c:pt idx="1">
                    <c:v>5.2684243507503137</c:v>
                  </c:pt>
                  <c:pt idx="2">
                    <c:v>5.4870795053388592</c:v>
                  </c:pt>
                </c:numCache>
              </c:numRef>
            </c:plus>
            <c:minus>
              <c:numRef>
                <c:f>'[Figure 2.6.xlsx]Sheet1'!$D$14,'[Figure 2.6.xlsx]Sheet1'!$D$26,'[Figure 2.6.xlsx]Sheet1'!$D$38</c:f>
                <c:numCache>
                  <c:formatCode>General</c:formatCode>
                  <c:ptCount val="3"/>
                  <c:pt idx="0">
                    <c:v>2.5253813613805267</c:v>
                  </c:pt>
                  <c:pt idx="1">
                    <c:v>5.2684243507503137</c:v>
                  </c:pt>
                  <c:pt idx="2">
                    <c:v>5.4870795053388592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D$13,'[Figure 2.6.xlsx]Sheet1'!$D$25,'[Figure 2.6.xlsx]Sheet1'!$D$37</c:f>
              <c:numCache>
                <c:formatCode>General</c:formatCode>
                <c:ptCount val="3"/>
                <c:pt idx="0">
                  <c:v>0.8928571428571429</c:v>
                </c:pt>
                <c:pt idx="1">
                  <c:v>22.087247606666114</c:v>
                </c:pt>
                <c:pt idx="2">
                  <c:v>68.202703729019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78-4C55-AA5D-672A2B3740CE}"/>
            </c:ext>
          </c:extLst>
        </c:ser>
        <c:ser>
          <c:idx val="1"/>
          <c:order val="1"/>
          <c:tx>
            <c:v>MGV1OX1</c:v>
          </c:tx>
          <c:spPr>
            <a:solidFill>
              <a:srgbClr val="FFC000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H$14,'[Figure 2.6.xlsx]Sheet1'!$H$26,'[Figure 2.6.xlsx]Sheet1'!$H$3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0.350844167610258</c:v>
                  </c:pt>
                  <c:pt idx="2">
                    <c:v>10.014092909224573</c:v>
                  </c:pt>
                </c:numCache>
              </c:numRef>
            </c:plus>
            <c:minus>
              <c:numRef>
                <c:f>'[Figure 2.6.xlsx]Sheet1'!$H$14,'[Figure 2.6.xlsx]Sheet1'!$H$26,'[Figure 2.6.xlsx]Sheet1'!$H$3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0.350844167610258</c:v>
                  </c:pt>
                  <c:pt idx="2">
                    <c:v>10.014092909224573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H$13,'[Figure 2.6.xlsx]Sheet1'!$H$25,'[Figure 2.6.xlsx]Sheet1'!$H$37</c:f>
              <c:numCache>
                <c:formatCode>General</c:formatCode>
                <c:ptCount val="3"/>
                <c:pt idx="0">
                  <c:v>0</c:v>
                </c:pt>
                <c:pt idx="1">
                  <c:v>22.343679712100766</c:v>
                </c:pt>
                <c:pt idx="2">
                  <c:v>67.641295290966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378-4C55-AA5D-672A2B3740CE}"/>
            </c:ext>
          </c:extLst>
        </c:ser>
        <c:ser>
          <c:idx val="2"/>
          <c:order val="2"/>
          <c:tx>
            <c:v>MGV1OX2</c:v>
          </c:tx>
          <c:spPr>
            <a:solidFill>
              <a:schemeClr val="accent2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L$14,'[Figure 2.6.xlsx]Sheet1'!$L$26,'[Figure 2.6.xlsx]Sheet1'!$L$3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290226092184195</c:v>
                  </c:pt>
                  <c:pt idx="2">
                    <c:v>6.0095660312467043</c:v>
                  </c:pt>
                </c:numCache>
              </c:numRef>
            </c:plus>
            <c:minus>
              <c:numRef>
                <c:f>'[Figure 2.6.xlsx]Sheet1'!$L$14,'[Figure 2.6.xlsx]Sheet1'!$L$26,'[Figure 2.6.xlsx]Sheet1'!$L$3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2.290226092184195</c:v>
                  </c:pt>
                  <c:pt idx="2">
                    <c:v>6.0095660312467043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L$13,'[Figure 2.6.xlsx]Sheet1'!$L$25,'[Figure 2.6.xlsx]Sheet1'!$L$37</c:f>
              <c:numCache>
                <c:formatCode>General</c:formatCode>
                <c:ptCount val="3"/>
                <c:pt idx="0">
                  <c:v>0</c:v>
                </c:pt>
                <c:pt idx="1">
                  <c:v>29.710962278403887</c:v>
                </c:pt>
                <c:pt idx="2">
                  <c:v>73.416337336912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378-4C55-AA5D-672A2B3740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374976"/>
        <c:axId val="99376512"/>
      </c:barChart>
      <c:catAx>
        <c:axId val="993749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algn="ctr">
                  <a:defRPr/>
                </a:pPr>
                <a:r>
                  <a:rPr lang="en-US"/>
                  <a:t>Time (hours) </a:t>
                </a:r>
              </a:p>
            </c:rich>
          </c:tx>
          <c:layout>
            <c:manualLayout>
              <c:xMode val="edge"/>
              <c:yMode val="edge"/>
              <c:x val="0.37064934503416452"/>
              <c:y val="0.852327450577283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99376512"/>
        <c:crosses val="autoZero"/>
        <c:auto val="1"/>
        <c:lblAlgn val="ctr"/>
        <c:lblOffset val="100"/>
        <c:noMultiLvlLbl val="0"/>
      </c:catAx>
      <c:valAx>
        <c:axId val="9937651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% macroconidia germination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99374976"/>
        <c:crosses val="autoZero"/>
        <c:crossBetween val="between"/>
        <c:majorUnit val="20"/>
      </c:valAx>
    </c:plotArea>
    <c:legend>
      <c:legendPos val="r"/>
      <c:legendEntry>
        <c:idx val="1"/>
        <c:txPr>
          <a:bodyPr/>
          <a:lstStyle/>
          <a:p>
            <a:pPr>
              <a:defRPr i="1"/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i="1"/>
            </a:pPr>
            <a:endParaRPr lang="en-US"/>
          </a:p>
        </c:txPr>
      </c:legendEntry>
      <c:overlay val="0"/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WT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Q$14,'[Figure 2.6.xlsx]Sheet1'!$Q$26,'[Figure 2.6.xlsx]Sheet1'!$Q$38</c:f>
                <c:numCache>
                  <c:formatCode>General</c:formatCode>
                  <c:ptCount val="3"/>
                  <c:pt idx="0">
                    <c:v>2.9791369599823803</c:v>
                  </c:pt>
                  <c:pt idx="1">
                    <c:v>7.642996438227307</c:v>
                  </c:pt>
                  <c:pt idx="2">
                    <c:v>5.9646096332647973</c:v>
                  </c:pt>
                </c:numCache>
              </c:numRef>
            </c:plus>
            <c:minus>
              <c:numRef>
                <c:f>'[Figure 2.6.xlsx]Sheet1'!$Q$14,'[Figure 2.6.xlsx]Sheet1'!$Q$26,'[Figure 2.6.xlsx]Sheet1'!$Q$38</c:f>
                <c:numCache>
                  <c:formatCode>General</c:formatCode>
                  <c:ptCount val="3"/>
                  <c:pt idx="0">
                    <c:v>2.9791369599823803</c:v>
                  </c:pt>
                  <c:pt idx="1">
                    <c:v>7.642996438227307</c:v>
                  </c:pt>
                  <c:pt idx="2">
                    <c:v>5.9646096332647973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Q$13,'[Figure 2.6.xlsx]Sheet1'!$Q$25,'[Figure 2.6.xlsx]Sheet1'!$Q$37</c:f>
              <c:numCache>
                <c:formatCode>General</c:formatCode>
                <c:ptCount val="3"/>
                <c:pt idx="0">
                  <c:v>0.57471264367816088</c:v>
                </c:pt>
                <c:pt idx="1">
                  <c:v>29.132442117416542</c:v>
                </c:pt>
                <c:pt idx="2">
                  <c:v>81.1063503402213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0E-4717-B412-8E6C010B3325}"/>
            </c:ext>
          </c:extLst>
        </c:ser>
        <c:ser>
          <c:idx val="1"/>
          <c:order val="1"/>
          <c:tx>
            <c:v>MGV1OX6</c:v>
          </c:tx>
          <c:spPr>
            <a:solidFill>
              <a:schemeClr val="accent5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U$14,'[Figure 2.6.xlsx]Sheet1'!$U$26,'[Figure 2.6.xlsx]Sheet1'!$U$38</c:f>
                <c:numCache>
                  <c:formatCode>General</c:formatCode>
                  <c:ptCount val="3"/>
                  <c:pt idx="0">
                    <c:v>1.4222191220204305</c:v>
                  </c:pt>
                  <c:pt idx="1">
                    <c:v>10.425415335530786</c:v>
                  </c:pt>
                  <c:pt idx="2">
                    <c:v>4.3992570788591285</c:v>
                  </c:pt>
                </c:numCache>
              </c:numRef>
            </c:plus>
            <c:minus>
              <c:numRef>
                <c:f>'[Figure 2.6.xlsx]Sheet1'!$U$14,'[Figure 2.6.xlsx]Sheet1'!$U$26,'[Figure 2.6.xlsx]Sheet1'!$U$38</c:f>
                <c:numCache>
                  <c:formatCode>General</c:formatCode>
                  <c:ptCount val="3"/>
                  <c:pt idx="0">
                    <c:v>1.4222191220204305</c:v>
                  </c:pt>
                  <c:pt idx="1">
                    <c:v>10.425415335530786</c:v>
                  </c:pt>
                  <c:pt idx="2">
                    <c:v>4.3992570788591285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U$13,'[Figure 2.6.xlsx]Sheet1'!$U$25,'[Figure 2.6.xlsx]Sheet1'!$U$37</c:f>
              <c:numCache>
                <c:formatCode>General</c:formatCode>
                <c:ptCount val="3"/>
                <c:pt idx="0">
                  <c:v>0.76388888888888884</c:v>
                </c:pt>
                <c:pt idx="1">
                  <c:v>41.295689248222558</c:v>
                </c:pt>
                <c:pt idx="2">
                  <c:v>83.3677061961908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0E-4717-B412-8E6C010B3325}"/>
            </c:ext>
          </c:extLst>
        </c:ser>
        <c:ser>
          <c:idx val="2"/>
          <c:order val="2"/>
          <c:tx>
            <c:v>MGV1OX8</c:v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2.6.xlsx]Sheet1'!$Y$14,'[Figure 2.6.xlsx]Sheet1'!$Y$26,'[Figure 2.6.xlsx]Sheet1'!$Y$38</c:f>
                <c:numCache>
                  <c:formatCode>General</c:formatCode>
                  <c:ptCount val="3"/>
                  <c:pt idx="0">
                    <c:v>0.95554970430614528</c:v>
                  </c:pt>
                  <c:pt idx="1">
                    <c:v>10.20608748385232</c:v>
                  </c:pt>
                  <c:pt idx="2">
                    <c:v>3.2606302674679277</c:v>
                  </c:pt>
                </c:numCache>
              </c:numRef>
            </c:plus>
            <c:minus>
              <c:numRef>
                <c:f>'[Figure 2.6.xlsx]Sheet1'!$Y$14,'[Figure 2.6.xlsx]Sheet1'!$Y$26,'[Figure 2.6.xlsx]Sheet1'!$Y$38</c:f>
                <c:numCache>
                  <c:formatCode>General</c:formatCode>
                  <c:ptCount val="3"/>
                  <c:pt idx="0">
                    <c:v>0.95554970430614528</c:v>
                  </c:pt>
                  <c:pt idx="1">
                    <c:v>10.20608748385232</c:v>
                  </c:pt>
                  <c:pt idx="2">
                    <c:v>3.2606302674679277</c:v>
                  </c:pt>
                </c:numCache>
              </c:numRef>
            </c:minus>
          </c:errBars>
          <c:cat>
            <c:numRef>
              <c:f>'[Figure 2.6.xlsx]Sheet1'!$AG$37:$AG$39</c:f>
              <c:numCache>
                <c:formatCode>General</c:formatCode>
                <c:ptCount val="3"/>
                <c:pt idx="0">
                  <c:v>3</c:v>
                </c:pt>
                <c:pt idx="1">
                  <c:v>6</c:v>
                </c:pt>
                <c:pt idx="2">
                  <c:v>8</c:v>
                </c:pt>
              </c:numCache>
            </c:numRef>
          </c:cat>
          <c:val>
            <c:numRef>
              <c:f>'[Figure 2.6.xlsx]Sheet1'!$Y$13,'[Figure 2.6.xlsx]Sheet1'!$Y$25,'[Figure 2.6.xlsx]Sheet1'!$Y$37</c:f>
              <c:numCache>
                <c:formatCode>General</c:formatCode>
                <c:ptCount val="3"/>
                <c:pt idx="0">
                  <c:v>0.33783783783783783</c:v>
                </c:pt>
                <c:pt idx="1">
                  <c:v>39.132527812360692</c:v>
                </c:pt>
                <c:pt idx="2">
                  <c:v>77.100944155971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0E-4717-B412-8E6C010B33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611968"/>
        <c:axId val="100613504"/>
      </c:barChart>
      <c:catAx>
        <c:axId val="10061196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algn="ctr">
                  <a:defRPr/>
                </a:pPr>
                <a:r>
                  <a:rPr lang="en-US"/>
                  <a:t>Time (hours) </a:t>
                </a:r>
              </a:p>
            </c:rich>
          </c:tx>
          <c:layout>
            <c:manualLayout>
              <c:xMode val="edge"/>
              <c:yMode val="edge"/>
              <c:x val="0.37060121698270865"/>
              <c:y val="0.846977868000874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0"/>
            </a:pPr>
            <a:endParaRPr lang="en-US"/>
          </a:p>
        </c:txPr>
        <c:crossAx val="100613504"/>
        <c:crosses val="autoZero"/>
        <c:auto val="1"/>
        <c:lblAlgn val="ctr"/>
        <c:lblOffset val="100"/>
        <c:noMultiLvlLbl val="0"/>
      </c:catAx>
      <c:valAx>
        <c:axId val="10061350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/>
                  <a:t>% macroconidia germination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00611968"/>
        <c:crosses val="autoZero"/>
        <c:crossBetween val="between"/>
        <c:majorUnit val="20"/>
      </c:valAx>
      <c:spPr>
        <a:noFill/>
        <a:ln w="25400">
          <a:noFill/>
        </a:ln>
      </c:spPr>
    </c:plotArea>
    <c:legend>
      <c:legendPos val="r"/>
      <c:legendEntry>
        <c:idx val="1"/>
        <c:txPr>
          <a:bodyPr/>
          <a:lstStyle/>
          <a:p>
            <a:pPr>
              <a:defRPr i="1"/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i="1"/>
            </a:pPr>
            <a:endParaRPr lang="en-US"/>
          </a:p>
        </c:txPr>
      </c:legendEntry>
      <c:overlay val="0"/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CA70-4235-A56F-803C3C3D6C30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A70-4235-A56F-803C3C3D6C30}"/>
                </c:ext>
              </c:extLst>
            </c:dLbl>
            <c:dLbl>
              <c:idx val="2"/>
              <c:layout>
                <c:manualLayout>
                  <c:x val="0"/>
                  <c:y val="-5.55555555555555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CA70-4235-A56F-803C3C3D6C30}"/>
                </c:ext>
              </c:extLst>
            </c:dLbl>
            <c:dLbl>
              <c:idx val="3"/>
              <c:layout>
                <c:manualLayout>
                  <c:x val="0"/>
                  <c:y val="-6.944444444444444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CA70-4235-A56F-803C3C3D6C30}"/>
                </c:ext>
              </c:extLst>
            </c:dLbl>
            <c:dLbl>
              <c:idx val="4"/>
              <c:layout>
                <c:manualLayout>
                  <c:x val="0"/>
                  <c:y val="-6.944444444444448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CA70-4235-A56F-803C3C3D6C30}"/>
                </c:ext>
              </c:extLst>
            </c:dLbl>
            <c:dLbl>
              <c:idx val="5"/>
              <c:layout>
                <c:manualLayout>
                  <c:x val="-2.043500681330625E-16"/>
                  <c:y val="-9.259259259259258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CA70-4235-A56F-803C3C3D6C3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Measurements!$AD$69:$AD$74</c:f>
                <c:numCache>
                  <c:formatCode>General</c:formatCode>
                  <c:ptCount val="6"/>
                  <c:pt idx="0">
                    <c:v>7.0810432285209508E-3</c:v>
                  </c:pt>
                  <c:pt idx="1">
                    <c:v>6.2864828692297267E-3</c:v>
                  </c:pt>
                  <c:pt idx="2">
                    <c:v>1.3387997326296518E-2</c:v>
                  </c:pt>
                  <c:pt idx="3">
                    <c:v>1.5243907502431016E-2</c:v>
                  </c:pt>
                  <c:pt idx="4">
                    <c:v>1.5385602496493919E-2</c:v>
                  </c:pt>
                  <c:pt idx="5">
                    <c:v>2.012618783145902E-2</c:v>
                  </c:pt>
                </c:numCache>
              </c:numRef>
            </c:plus>
            <c:minus>
              <c:numRef>
                <c:f>Measurements!$AD$69:$AD$74</c:f>
                <c:numCache>
                  <c:formatCode>General</c:formatCode>
                  <c:ptCount val="6"/>
                  <c:pt idx="0">
                    <c:v>7.0810432285209508E-3</c:v>
                  </c:pt>
                  <c:pt idx="1">
                    <c:v>6.2864828692297267E-3</c:v>
                  </c:pt>
                  <c:pt idx="2">
                    <c:v>1.3387997326296518E-2</c:v>
                  </c:pt>
                  <c:pt idx="3">
                    <c:v>1.5243907502431016E-2</c:v>
                  </c:pt>
                  <c:pt idx="4">
                    <c:v>1.5385602496493919E-2</c:v>
                  </c:pt>
                  <c:pt idx="5">
                    <c:v>2.0126187831459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easurements!$AB$69:$AB$74</c:f>
              <c:strCache>
                <c:ptCount val="6"/>
                <c:pt idx="0">
                  <c:v>WT</c:v>
                </c:pt>
                <c:pt idx="1">
                  <c:v>Δmgv1</c:v>
                </c:pt>
                <c:pt idx="2">
                  <c:v>MGV1Oex1</c:v>
                </c:pt>
                <c:pt idx="3">
                  <c:v>MGV1Oex2</c:v>
                </c:pt>
                <c:pt idx="4">
                  <c:v>MGV1Oex6</c:v>
                </c:pt>
                <c:pt idx="5">
                  <c:v>MGV1Oex8</c:v>
                </c:pt>
              </c:strCache>
            </c:strRef>
          </c:cat>
          <c:val>
            <c:numRef>
              <c:f>Measurements!$AC$69:$AC$74</c:f>
              <c:numCache>
                <c:formatCode>General</c:formatCode>
                <c:ptCount val="6"/>
                <c:pt idx="0">
                  <c:v>3.4743126720306231E-2</c:v>
                </c:pt>
                <c:pt idx="1">
                  <c:v>4.2792019433999948E-2</c:v>
                </c:pt>
                <c:pt idx="2">
                  <c:v>0.1209006927155567</c:v>
                </c:pt>
                <c:pt idx="3">
                  <c:v>9.8803391098113938E-2</c:v>
                </c:pt>
                <c:pt idx="4">
                  <c:v>0.10436040841818345</c:v>
                </c:pt>
                <c:pt idx="5">
                  <c:v>0.120802805734380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A70-4235-A56F-803C3C3D6C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1"/>
        <c:overlap val="-32"/>
        <c:axId val="2036905776"/>
        <c:axId val="2036906256"/>
      </c:barChart>
      <c:catAx>
        <c:axId val="2036905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i="1" dirty="0"/>
                  <a:t>F. graminearum</a:t>
                </a:r>
                <a:r>
                  <a:rPr lang="en-US" b="1" dirty="0"/>
                  <a:t> strain</a:t>
                </a:r>
              </a:p>
            </c:rich>
          </c:tx>
          <c:layout>
            <c:manualLayout>
              <c:xMode val="edge"/>
              <c:yMode val="edge"/>
              <c:x val="0.41744357258498677"/>
              <c:y val="0.924758218174237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36906256"/>
        <c:crosses val="autoZero"/>
        <c:auto val="1"/>
        <c:lblAlgn val="ctr"/>
        <c:lblOffset val="100"/>
        <c:noMultiLvlLbl val="0"/>
      </c:catAx>
      <c:valAx>
        <c:axId val="20369062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µg 15ADON per mg of mycelium</a:t>
                </a:r>
              </a:p>
            </c:rich>
          </c:tx>
          <c:layout>
            <c:manualLayout>
              <c:xMode val="edge"/>
              <c:yMode val="edge"/>
              <c:x val="1.2130733974086528E-2"/>
              <c:y val="0.103232903238479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36905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ll Roblin SPSS'!$AB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Roblin SPSS'!$AI$4:$AK$4</c:f>
                <c:numCache>
                  <c:formatCode>General</c:formatCode>
                  <c:ptCount val="3"/>
                  <c:pt idx="0">
                    <c:v>0.31572541817620525</c:v>
                  </c:pt>
                  <c:pt idx="1">
                    <c:v>0.4078592972450259</c:v>
                  </c:pt>
                  <c:pt idx="2">
                    <c:v>0.36253078686998635</c:v>
                  </c:pt>
                </c:numCache>
              </c:numRef>
            </c:plus>
            <c:minus>
              <c:numRef>
                <c:f>'all Roblin SPSS'!$AI$4:$AK$4</c:f>
                <c:numCache>
                  <c:formatCode>General</c:formatCode>
                  <c:ptCount val="3"/>
                  <c:pt idx="0">
                    <c:v>0.31572541817620525</c:v>
                  </c:pt>
                  <c:pt idx="1">
                    <c:v>0.4078592972450259</c:v>
                  </c:pt>
                  <c:pt idx="2">
                    <c:v>0.362530786869986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Roblin SPSS'!$AC$3:$AE$3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Roblin SPSS'!$AC$4:$AE$4</c:f>
              <c:numCache>
                <c:formatCode>General</c:formatCode>
                <c:ptCount val="3"/>
                <c:pt idx="0">
                  <c:v>3.2666666666666666</c:v>
                </c:pt>
                <c:pt idx="1">
                  <c:v>7.9333333333333336</c:v>
                </c:pt>
                <c:pt idx="2">
                  <c:v>1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477-4556-806F-7821443221B2}"/>
            </c:ext>
          </c:extLst>
        </c:ser>
        <c:ser>
          <c:idx val="1"/>
          <c:order val="1"/>
          <c:tx>
            <c:strRef>
              <c:f>'all Roblin SPSS'!$AB$5</c:f>
              <c:strCache>
                <c:ptCount val="1"/>
                <c:pt idx="0">
                  <c:v>MGV1Oex1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Roblin SPSS'!$AI$5:$AK$5</c:f>
                <c:numCache>
                  <c:formatCode>General</c:formatCode>
                  <c:ptCount val="3"/>
                  <c:pt idx="0">
                    <c:v>0.41018772318777202</c:v>
                  </c:pt>
                  <c:pt idx="1">
                    <c:v>0.49248317995611035</c:v>
                  </c:pt>
                  <c:pt idx="2">
                    <c:v>0.40237390808147822</c:v>
                  </c:pt>
                </c:numCache>
              </c:numRef>
            </c:plus>
            <c:minus>
              <c:numRef>
                <c:f>'all Roblin SPSS'!$AI$5:$AK$5</c:f>
                <c:numCache>
                  <c:formatCode>General</c:formatCode>
                  <c:ptCount val="3"/>
                  <c:pt idx="0">
                    <c:v>0.41018772318777202</c:v>
                  </c:pt>
                  <c:pt idx="1">
                    <c:v>0.49248317995611035</c:v>
                  </c:pt>
                  <c:pt idx="2">
                    <c:v>0.402373908081478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Roblin SPSS'!$AC$3:$AE$3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Roblin SPSS'!$AC$5:$AE$5</c:f>
              <c:numCache>
                <c:formatCode>General</c:formatCode>
                <c:ptCount val="3"/>
                <c:pt idx="0">
                  <c:v>3.3333333333333335</c:v>
                </c:pt>
                <c:pt idx="1">
                  <c:v>7.7333333333333334</c:v>
                </c:pt>
                <c:pt idx="2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477-4556-806F-7821443221B2}"/>
            </c:ext>
          </c:extLst>
        </c:ser>
        <c:ser>
          <c:idx val="2"/>
          <c:order val="2"/>
          <c:tx>
            <c:strRef>
              <c:f>'all Roblin SPSS'!$AB$6</c:f>
              <c:strCache>
                <c:ptCount val="1"/>
                <c:pt idx="0">
                  <c:v>MGV1Oex2</c:v>
                </c:pt>
              </c:strCache>
            </c:strRef>
          </c:tx>
          <c:spPr>
            <a:solidFill>
              <a:srgbClr val="C0504D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Roblin SPSS'!$AI$6:$AK$6</c:f>
                <c:numCache>
                  <c:formatCode>General</c:formatCode>
                  <c:ptCount val="3"/>
                  <c:pt idx="0">
                    <c:v>0.30341966327759978</c:v>
                  </c:pt>
                  <c:pt idx="1">
                    <c:v>0.4</c:v>
                  </c:pt>
                  <c:pt idx="2">
                    <c:v>0.32170182388675306</c:v>
                  </c:pt>
                </c:numCache>
              </c:numRef>
            </c:plus>
            <c:minus>
              <c:numRef>
                <c:f>'all Roblin SPSS'!$AI$6:$AK$6</c:f>
                <c:numCache>
                  <c:formatCode>General</c:formatCode>
                  <c:ptCount val="3"/>
                  <c:pt idx="0">
                    <c:v>0.30341966327759978</c:v>
                  </c:pt>
                  <c:pt idx="1">
                    <c:v>0.4</c:v>
                  </c:pt>
                  <c:pt idx="2">
                    <c:v>0.321701823886753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Roblin SPSS'!$AC$3:$AE$3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Roblin SPSS'!$AC$6:$AE$6</c:f>
              <c:numCache>
                <c:formatCode>General</c:formatCode>
                <c:ptCount val="3"/>
                <c:pt idx="0">
                  <c:v>3.3333333333333335</c:v>
                </c:pt>
                <c:pt idx="1">
                  <c:v>7.6</c:v>
                </c:pt>
                <c:pt idx="2">
                  <c:v>10.5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477-4556-806F-7821443221B2}"/>
            </c:ext>
          </c:extLst>
        </c:ser>
        <c:ser>
          <c:idx val="3"/>
          <c:order val="3"/>
          <c:tx>
            <c:strRef>
              <c:f>'all Roblin SPSS'!$AB$7</c:f>
              <c:strCache>
                <c:ptCount val="1"/>
                <c:pt idx="0">
                  <c:v>MGV1Oex3</c:v>
                </c:pt>
              </c:strCache>
            </c:strRef>
          </c:tx>
          <c:spPr>
            <a:solidFill>
              <a:srgbClr val="5B9BD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Roblin SPSS'!$AI$7:$AK$7</c:f>
                <c:numCache>
                  <c:formatCode>General</c:formatCode>
                  <c:ptCount val="3"/>
                  <c:pt idx="0">
                    <c:v>0.30550504633038938</c:v>
                  </c:pt>
                  <c:pt idx="1">
                    <c:v>0.52974986610184305</c:v>
                  </c:pt>
                  <c:pt idx="2">
                    <c:v>0.33617833513757694</c:v>
                  </c:pt>
                </c:numCache>
              </c:numRef>
            </c:plus>
            <c:minus>
              <c:numRef>
                <c:f>'all Roblin SPSS'!$AI$7:$AK$7</c:f>
                <c:numCache>
                  <c:formatCode>General</c:formatCode>
                  <c:ptCount val="3"/>
                  <c:pt idx="0">
                    <c:v>0.30550504633038938</c:v>
                  </c:pt>
                  <c:pt idx="1">
                    <c:v>0.52974986610184305</c:v>
                  </c:pt>
                  <c:pt idx="2">
                    <c:v>0.336178335137576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Roblin SPSS'!$AC$3:$AE$3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Roblin SPSS'!$AC$7:$AE$7</c:f>
              <c:numCache>
                <c:formatCode>General</c:formatCode>
                <c:ptCount val="3"/>
                <c:pt idx="0">
                  <c:v>3.6</c:v>
                </c:pt>
                <c:pt idx="1">
                  <c:v>8.0666666666666664</c:v>
                </c:pt>
                <c:pt idx="2">
                  <c:v>10.5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477-4556-806F-7821443221B2}"/>
            </c:ext>
          </c:extLst>
        </c:ser>
        <c:ser>
          <c:idx val="4"/>
          <c:order val="4"/>
          <c:tx>
            <c:strRef>
              <c:f>'all Roblin SPSS'!$AB$8</c:f>
              <c:strCache>
                <c:ptCount val="1"/>
                <c:pt idx="0">
                  <c:v>MGV1Oex4</c:v>
                </c:pt>
              </c:strCache>
            </c:strRef>
          </c:tx>
          <c:spPr>
            <a:solidFill>
              <a:srgbClr val="8064A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Roblin SPSS'!$AI$8:$AK$8</c:f>
                <c:numCache>
                  <c:formatCode>General</c:formatCode>
                  <c:ptCount val="3"/>
                  <c:pt idx="0">
                    <c:v>0.43424811867344754</c:v>
                  </c:pt>
                  <c:pt idx="1">
                    <c:v>0.64635731432217725</c:v>
                  </c:pt>
                  <c:pt idx="2">
                    <c:v>0.37628088124073167</c:v>
                  </c:pt>
                </c:numCache>
              </c:numRef>
            </c:plus>
            <c:minus>
              <c:numRef>
                <c:f>'all Roblin SPSS'!$AI$8:$AK$8</c:f>
                <c:numCache>
                  <c:formatCode>General</c:formatCode>
                  <c:ptCount val="3"/>
                  <c:pt idx="0">
                    <c:v>0.43424811867344754</c:v>
                  </c:pt>
                  <c:pt idx="1">
                    <c:v>0.64635731432217725</c:v>
                  </c:pt>
                  <c:pt idx="2">
                    <c:v>0.376280881240731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Roblin SPSS'!$AC$3:$AE$3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Roblin SPSS'!$AC$8:$AE$8</c:f>
              <c:numCache>
                <c:formatCode>General</c:formatCode>
                <c:ptCount val="3"/>
                <c:pt idx="0">
                  <c:v>3.4</c:v>
                </c:pt>
                <c:pt idx="1">
                  <c:v>7.1333333333333337</c:v>
                </c:pt>
                <c:pt idx="2">
                  <c:v>10.4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477-4556-806F-7821443221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6372512"/>
        <c:axId val="426370112"/>
      </c:barChart>
      <c:catAx>
        <c:axId val="42637251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Days after inocula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6370112"/>
        <c:crosses val="autoZero"/>
        <c:auto val="1"/>
        <c:lblAlgn val="ctr"/>
        <c:lblOffset val="100"/>
        <c:noMultiLvlLbl val="0"/>
      </c:catAx>
      <c:valAx>
        <c:axId val="4263701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Number of diseased spikeletes/spike</a:t>
                </a:r>
              </a:p>
            </c:rich>
          </c:tx>
          <c:layout>
            <c:manualLayout>
              <c:xMode val="edge"/>
              <c:yMode val="edge"/>
              <c:x val="3.1297022544206428E-3"/>
              <c:y val="0.173556064877487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26372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ll Penhold SPSS'!$AB$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Penhold SPSS'!$AI$3:$AK$3</c:f>
                <c:numCache>
                  <c:formatCode>General</c:formatCode>
                  <c:ptCount val="3"/>
                  <c:pt idx="0">
                    <c:v>0.27371634025142694</c:v>
                  </c:pt>
                  <c:pt idx="1">
                    <c:v>0.59521904731427588</c:v>
                  </c:pt>
                  <c:pt idx="2">
                    <c:v>0.43424811867344754</c:v>
                  </c:pt>
                </c:numCache>
              </c:numRef>
            </c:plus>
            <c:minus>
              <c:numRef>
                <c:f>'all Penhold SPSS'!$AI$3:$AK$3</c:f>
                <c:numCache>
                  <c:formatCode>General</c:formatCode>
                  <c:ptCount val="3"/>
                  <c:pt idx="0">
                    <c:v>0.27371634025142694</c:v>
                  </c:pt>
                  <c:pt idx="1">
                    <c:v>0.59521904731427588</c:v>
                  </c:pt>
                  <c:pt idx="2">
                    <c:v>0.434248118673447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Penhold SPSS'!$AC$2:$AE$2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Penhold SPSS'!$AC$3:$AE$3</c:f>
              <c:numCache>
                <c:formatCode>General</c:formatCode>
                <c:ptCount val="3"/>
                <c:pt idx="0">
                  <c:v>2.5333333333333332</c:v>
                </c:pt>
                <c:pt idx="1">
                  <c:v>7.8</c:v>
                </c:pt>
                <c:pt idx="2">
                  <c:v>12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03-4C78-9E8A-428E6204A011}"/>
            </c:ext>
          </c:extLst>
        </c:ser>
        <c:ser>
          <c:idx val="1"/>
          <c:order val="1"/>
          <c:tx>
            <c:strRef>
              <c:f>'all Penhold SPSS'!$AB$4</c:f>
              <c:strCache>
                <c:ptCount val="1"/>
                <c:pt idx="0">
                  <c:v>MGV1_OX1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Penhold SPSS'!$AI$4:$AK$4</c:f>
                <c:numCache>
                  <c:formatCode>General</c:formatCode>
                  <c:ptCount val="3"/>
                  <c:pt idx="0">
                    <c:v>0.18170270503179914</c:v>
                  </c:pt>
                  <c:pt idx="1">
                    <c:v>0.62233559057922061</c:v>
                  </c:pt>
                  <c:pt idx="2">
                    <c:v>0.81571859449005157</c:v>
                  </c:pt>
                </c:numCache>
              </c:numRef>
            </c:plus>
            <c:minus>
              <c:numRef>
                <c:f>'all Penhold SPSS'!$AI$4:$AK$4</c:f>
                <c:numCache>
                  <c:formatCode>General</c:formatCode>
                  <c:ptCount val="3"/>
                  <c:pt idx="0">
                    <c:v>0.18170270503179914</c:v>
                  </c:pt>
                  <c:pt idx="1">
                    <c:v>0.62233559057922061</c:v>
                  </c:pt>
                  <c:pt idx="2">
                    <c:v>0.815718594490051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Penhold SPSS'!$AC$2:$AE$2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Penhold SPSS'!$AC$4:$AE$4</c:f>
              <c:numCache>
                <c:formatCode>General</c:formatCode>
                <c:ptCount val="3"/>
                <c:pt idx="0">
                  <c:v>1.9333333333333333</c:v>
                </c:pt>
                <c:pt idx="1">
                  <c:v>6.333333333333333</c:v>
                </c:pt>
                <c:pt idx="2">
                  <c:v>11.1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03-4C78-9E8A-428E6204A011}"/>
            </c:ext>
          </c:extLst>
        </c:ser>
        <c:ser>
          <c:idx val="2"/>
          <c:order val="2"/>
          <c:tx>
            <c:strRef>
              <c:f>'all Penhold SPSS'!$AB$5</c:f>
              <c:strCache>
                <c:ptCount val="1"/>
                <c:pt idx="0">
                  <c:v>MGV1_OX2</c:v>
                </c:pt>
              </c:strCache>
            </c:strRef>
          </c:tx>
          <c:spPr>
            <a:solidFill>
              <a:srgbClr val="C0504D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Penhold SPSS'!$AI$5:$AK$5</c:f>
                <c:numCache>
                  <c:formatCode>General</c:formatCode>
                  <c:ptCount val="3"/>
                  <c:pt idx="0">
                    <c:v>0.29059326290271159</c:v>
                  </c:pt>
                  <c:pt idx="1">
                    <c:v>0.75508855782532569</c:v>
                  </c:pt>
                  <c:pt idx="2">
                    <c:v>1.060996835864408</c:v>
                  </c:pt>
                </c:numCache>
              </c:numRef>
            </c:plus>
            <c:minus>
              <c:numRef>
                <c:f>'all Penhold SPSS'!$AI$5:$AK$5</c:f>
                <c:numCache>
                  <c:formatCode>General</c:formatCode>
                  <c:ptCount val="3"/>
                  <c:pt idx="0">
                    <c:v>0.29059326290271159</c:v>
                  </c:pt>
                  <c:pt idx="1">
                    <c:v>0.75508855782532569</c:v>
                  </c:pt>
                  <c:pt idx="2">
                    <c:v>1.0609968358644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Penhold SPSS'!$AC$2:$AE$2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Penhold SPSS'!$AC$5:$AE$5</c:f>
              <c:numCache>
                <c:formatCode>General</c:formatCode>
                <c:ptCount val="3"/>
                <c:pt idx="0">
                  <c:v>2.1333333333333333</c:v>
                </c:pt>
                <c:pt idx="1">
                  <c:v>5.4666666666666668</c:v>
                </c:pt>
                <c:pt idx="2">
                  <c:v>9.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003-4C78-9E8A-428E6204A011}"/>
            </c:ext>
          </c:extLst>
        </c:ser>
        <c:ser>
          <c:idx val="3"/>
          <c:order val="3"/>
          <c:tx>
            <c:strRef>
              <c:f>'all Penhold SPSS'!$AB$6</c:f>
              <c:strCache>
                <c:ptCount val="1"/>
                <c:pt idx="0">
                  <c:v>MGV1_OX6</c:v>
                </c:pt>
              </c:strCache>
            </c:strRef>
          </c:tx>
          <c:spPr>
            <a:solidFill>
              <a:srgbClr val="5B9BD5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Penhold SPSS'!$AI$6:$AK$6</c:f>
                <c:numCache>
                  <c:formatCode>General</c:formatCode>
                  <c:ptCount val="3"/>
                  <c:pt idx="0">
                    <c:v>0.30341966327759978</c:v>
                  </c:pt>
                  <c:pt idx="1">
                    <c:v>0.50205925154656006</c:v>
                  </c:pt>
                  <c:pt idx="2">
                    <c:v>0.33046383948376135</c:v>
                  </c:pt>
                </c:numCache>
              </c:numRef>
            </c:plus>
            <c:minus>
              <c:numRef>
                <c:f>'all Penhold SPSS'!$AI$6:$AK$6</c:f>
                <c:numCache>
                  <c:formatCode>General</c:formatCode>
                  <c:ptCount val="3"/>
                  <c:pt idx="0">
                    <c:v>0.30341966327759978</c:v>
                  </c:pt>
                  <c:pt idx="1">
                    <c:v>0.50205925154656006</c:v>
                  </c:pt>
                  <c:pt idx="2">
                    <c:v>0.330463839483761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Penhold SPSS'!$AC$2:$AE$2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Penhold SPSS'!$AC$6:$AE$6</c:f>
              <c:numCache>
                <c:formatCode>General</c:formatCode>
                <c:ptCount val="3"/>
                <c:pt idx="0">
                  <c:v>2.3333333333333335</c:v>
                </c:pt>
                <c:pt idx="1">
                  <c:v>7.2666666666666666</c:v>
                </c:pt>
                <c:pt idx="2">
                  <c:v>11.9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003-4C78-9E8A-428E6204A011}"/>
            </c:ext>
          </c:extLst>
        </c:ser>
        <c:ser>
          <c:idx val="4"/>
          <c:order val="4"/>
          <c:tx>
            <c:strRef>
              <c:f>'all Penhold SPSS'!$AB$7</c:f>
              <c:strCache>
                <c:ptCount val="1"/>
                <c:pt idx="0">
                  <c:v>MGV1_OX8</c:v>
                </c:pt>
              </c:strCache>
            </c:strRef>
          </c:tx>
          <c:spPr>
            <a:solidFill>
              <a:srgbClr val="8064A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ll Penhold SPSS'!$AI$7:$AK$7</c:f>
                <c:numCache>
                  <c:formatCode>General</c:formatCode>
                  <c:ptCount val="3"/>
                  <c:pt idx="0">
                    <c:v>0.22253945610567472</c:v>
                  </c:pt>
                  <c:pt idx="1">
                    <c:v>0.69556417662896053</c:v>
                  </c:pt>
                  <c:pt idx="2">
                    <c:v>0.93197179601714797</c:v>
                  </c:pt>
                </c:numCache>
              </c:numRef>
            </c:plus>
            <c:minus>
              <c:numRef>
                <c:f>'all Penhold SPSS'!$AI$7:$AK$7</c:f>
                <c:numCache>
                  <c:formatCode>General</c:formatCode>
                  <c:ptCount val="3"/>
                  <c:pt idx="0">
                    <c:v>0.22253945610567472</c:v>
                  </c:pt>
                  <c:pt idx="1">
                    <c:v>0.69556417662896053</c:v>
                  </c:pt>
                  <c:pt idx="2">
                    <c:v>0.931971796017147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all Penhold SPSS'!$AC$2:$AE$2</c:f>
              <c:numCache>
                <c:formatCode>General</c:formatCode>
                <c:ptCount val="3"/>
                <c:pt idx="0">
                  <c:v>7</c:v>
                </c:pt>
                <c:pt idx="1">
                  <c:v>12</c:v>
                </c:pt>
                <c:pt idx="2">
                  <c:v>18</c:v>
                </c:pt>
              </c:numCache>
            </c:numRef>
          </c:cat>
          <c:val>
            <c:numRef>
              <c:f>'all Penhold SPSS'!$AC$7:$AE$7</c:f>
              <c:numCache>
                <c:formatCode>General</c:formatCode>
                <c:ptCount val="3"/>
                <c:pt idx="0">
                  <c:v>2.2000000000000002</c:v>
                </c:pt>
                <c:pt idx="1">
                  <c:v>6.4</c:v>
                </c:pt>
                <c:pt idx="2">
                  <c:v>1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003-4C78-9E8A-428E6204A0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776352"/>
        <c:axId val="105771072"/>
      </c:barChart>
      <c:catAx>
        <c:axId val="1057763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>
                    <a:solidFill>
                      <a:schemeClr val="tx1"/>
                    </a:solidFill>
                  </a:rPr>
                  <a:t>Days after inoculation</a:t>
                </a:r>
              </a:p>
            </c:rich>
          </c:tx>
          <c:layout>
            <c:manualLayout>
              <c:xMode val="edge"/>
              <c:yMode val="edge"/>
              <c:x val="0.29457850671486568"/>
              <c:y val="0.895924084225763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771072"/>
        <c:crosses val="autoZero"/>
        <c:auto val="1"/>
        <c:lblAlgn val="ctr"/>
        <c:lblOffset val="100"/>
        <c:noMultiLvlLbl val="0"/>
      </c:catAx>
      <c:valAx>
        <c:axId val="105771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776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3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4"/>
        <c:txPr>
          <a:bodyPr rot="0" spcFirstLastPara="1" vertOverflow="ellipsis" vert="horz" wrap="square" anchor="ctr" anchorCtr="1"/>
          <a:lstStyle/>
          <a:p>
            <a:pPr>
              <a:defRPr sz="10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7362893186103433"/>
          <c:y val="0.24199344434168651"/>
          <c:w val="0.25829426333089239"/>
          <c:h val="0.568970678247038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882</cdr:x>
      <cdr:y>0.49454</cdr:y>
    </cdr:from>
    <cdr:to>
      <cdr:x>0.37962</cdr:x>
      <cdr:y>0.5849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CF1FA808-CAF4-33AC-2C1A-EAE30C12F635}"/>
            </a:ext>
          </a:extLst>
        </cdr:cNvPr>
        <cdr:cNvSpPr txBox="1"/>
      </cdr:nvSpPr>
      <cdr:spPr>
        <a:xfrm xmlns:a="http://schemas.openxmlformats.org/drawingml/2006/main">
          <a:off x="1580381" y="1560960"/>
          <a:ext cx="362279" cy="285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CA" sz="1100" dirty="0"/>
            <a:t>ns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B3AD4E-B92E-4DAA-9D32-389D36D4CB15}" type="datetimeFigureOut">
              <a:rPr lang="en-CA" smtClean="0"/>
              <a:t>2023-08-0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00FEE8-3DA4-49CC-A245-563CCE031E3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18590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537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007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81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785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287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308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903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148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195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222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F8B1B-166D-45DB-A1A6-6CFEA084CB59}" type="datetimeFigureOut">
              <a:rPr lang="en-US" smtClean="0"/>
              <a:t>8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17385-22BC-42E2-89D8-578A1E47CD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20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4029758-A6AB-8AE4-366B-AD3AF4516171}"/>
              </a:ext>
            </a:extLst>
          </p:cNvPr>
          <p:cNvSpPr txBox="1"/>
          <p:nvPr/>
        </p:nvSpPr>
        <p:spPr>
          <a:xfrm>
            <a:off x="2338968" y="145896"/>
            <a:ext cx="4466063" cy="60889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CTGGACCCAGACCCAGTCTAACTGCTCCCATTCCACCTCGCTCGACCCAACCAACTTGGGAAAGGAACCAACCAGCAATTGTCTTGTCTGTCAGGTACCTGCCTTTGCCTCCATACATATATCGCAAGAGAGACGCGCTGACTGTTTCTTTGTCTTTGTTCTTTTTCACTGTCACTGCATTGCTCCTGTTTCATCTCATCTCTATATCCCTCTTACCTACAACTCTCTGCATC</a:t>
            </a:r>
            <a:r>
              <a:rPr lang="en-US" sz="1050" b="1" dirty="0">
                <a:solidFill>
                  <a:srgbClr val="000000"/>
                </a:solidFill>
                <a:highlight>
                  <a:srgbClr val="FFFF00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CCA</a:t>
            </a:r>
            <a:r>
              <a:rPr lang="en-US" sz="825" dirty="0">
                <a:solidFill>
                  <a:srgbClr val="000000"/>
                </a:solidFill>
                <a:highlight>
                  <a:srgbClr val="FFFF00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CGTAGCGACATTCCCCTTGC</a:t>
            </a:r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AACCTTGTCGCATATTCGAAGCTTCCATTGCCCCGCACATACACCACCACACAAATACACC</a:t>
            </a:r>
            <a:r>
              <a:rPr lang="en-US" sz="1050" b="1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TG</a:t>
            </a:r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GGCGACCTACAAGGACGGAAGGTCTTCAAGGTCTTTAACCAGGACTTTGTTGTTGATGAGCGCTACACTGTCACCAAGGAGCTCGGCCAGGGAGCTTACGGTATCGTCTGGTGAGTTTGCGCATCTCGTTGCCCAGAACACTTTCTCTGTGCTGCGACTCGAAACTCTTTTACCTCGTCTTCTTCTACCCCGCCGCAGCTGCTGACGATAGCCCCGCCTCCCAGTGCCGCCGTCAACAACCAAACCAACGAGGGCGTAGCCATCAAGAAGGTCACCAATGTTTTTAGCAAGAAGATTCTGGCCAAGCGCGCCCTGCGCGAGATCAAGCTGCTCCAGCACTTCCGCGGCCACCGCAACGTGAGTTTCTGCCTCGGCGCAACAGACAAGGGACGCGTATGCTGATAGCTTCATCCCATCAGATCACATGTTTGTACGACATGGACATTCCTCGACCCGATAACTTCAACGAGACCTACTTGTACGAGGGTCAGTGACGATGCCTCCCCGAAAGACGAAAGAATGAACAATAAGCTGACACGGCACAGAGCTGATGGAGTGTGATTTGGCTGCCATCATCCGATCTGGCCAGCCTCTTACCGACGCCCACTTCCAATCCTTTATCTACCAGATCCTTTGCGGTCTCAAGTACATCCACTCCGCAAACGTTCTGCACCGAGATCTCAAGCCCGGTAACCTGCTTGTCAACGCCGACTGCGAGCTCAAGATTTGCGATTTCGGTCTTGCCCGAGGTTTCTCAGTCGACCCCGAAGAGAATGCTGGATACATGACCGAGTACGTCGCTACTCGATGGTACCGTGCACCTGAGATTATGTTGAGCTTCCAGAGCTACACCAAAGCTAGTACGTGTGATCGAAAATAA</a:t>
            </a:r>
            <a:r>
              <a:rPr lang="en-US" sz="825" dirty="0">
                <a:solidFill>
                  <a:srgbClr val="000000"/>
                </a:solidFill>
                <a:highlight>
                  <a:srgbClr val="A9A9A9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CTGTGGCTGTGGGATGACTT</a:t>
            </a:r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ACTGACTTGTTGTAGTTGATGTTTGGTCTGTTGGTTGTATTCTGGCTGAGCTTTTGGGCGGACGACCTTTCTTCAAGGGCCGTGACTACGTCGACCAGCTGAACCAGATTCTTCACATTCTCGGAACCCCCAACGAGGAGACCCTCTCCCGTATCGGCTCACCCCGTGCCCAGGAATACGTCCGCAACCTACCTTTCATGCCCAAGAAGCCTTTCCCCAGCCTGTTCCCCCAGGCCAACCCCGACGCTCTCGACCTTCTCGACAAGATGCTCGCCTTCGACCCTTCGTCCCGTATCAGTGTAGAGCAGGCTCTCGAGCACCCTTACCTGCAAATTTGGCATGACGCCTCGGACGAGCCCGACTGCCCCACCACATTCAACTTCGACTTTGAGGTTGTTGAGGACGTTGGTCAGATGCGTGGTATGATTTTGGATGAGGTTCAACGATTCCGACAGAATGTCCGTACCGTGCCCGGCCAAAGCGGTGGAGGTCTTCAGGGCCAGGGTGTCCCCGTTCCTCTGCCTCAGGGTAATGGTCAATGGACTGCTGAGGACCCTCGACCTCAGGAATATGCTGGTCATGGTAACACCGGACTTGAGCAGG</a:t>
            </a:r>
            <a:r>
              <a:rPr lang="en-US" sz="825" dirty="0">
                <a:solidFill>
                  <a:srgbClr val="000000"/>
                </a:solidFill>
                <a:highlight>
                  <a:srgbClr val="D3D3D3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ATCTTCAGGGAGGCCTGGAT</a:t>
            </a:r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GCTTCTCGAAGA</a:t>
            </a:r>
            <a:r>
              <a:rPr lang="en-US" sz="1050" b="1" dirty="0">
                <a:solidFill>
                  <a:srgbClr val="FF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TAA</a:t>
            </a:r>
            <a:r>
              <a:rPr lang="en-US" sz="825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GAGCTGCTACGCAAAGTACAAGGGTTGAAAAAGGATATATCCTAGAGGATTAAGAACGGCATGCTCTCTGGTTCAAAATGAAAGATACA</a:t>
            </a:r>
            <a:r>
              <a:rPr lang="en-US" sz="1050" b="1" dirty="0">
                <a:solidFill>
                  <a:srgbClr val="000000"/>
                </a:solidFill>
                <a:highlight>
                  <a:srgbClr val="00FFFF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C</a:t>
            </a:r>
            <a:r>
              <a:rPr lang="en-US" sz="1050" b="1" u="sng" dirty="0">
                <a:solidFill>
                  <a:srgbClr val="000000"/>
                </a:solidFill>
                <a:highlight>
                  <a:srgbClr val="00FFFF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CCA</a:t>
            </a:r>
            <a:r>
              <a:rPr lang="en-US" sz="825" u="sng" dirty="0">
                <a:solidFill>
                  <a:srgbClr val="000000"/>
                </a:solidFill>
                <a:highlight>
                  <a:srgbClr val="00FFFF"/>
                </a:highlight>
                <a:latin typeface="Calibri" panose="020F0502020204030204" pitchFamily="34" charset="0"/>
                <a:ea typeface="Times New Roman" panose="02020603050405020304" pitchFamily="18" charset="0"/>
              </a:rPr>
              <a:t>AGGCACTGGAAATAGGGAC</a:t>
            </a:r>
            <a:r>
              <a:rPr lang="en-US" sz="825" u="sng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G</a:t>
            </a:r>
          </a:p>
          <a:p>
            <a:endParaRPr lang="en-US" sz="825" u="sng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SG_10313_Up_RScrRNA_1: </a:t>
            </a:r>
            <a:r>
              <a:rPr lang="en-US" sz="750" dirty="0">
                <a:solidFill>
                  <a:srgbClr val="000000"/>
                </a:solidFill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CAAGGGGAATGTCGCTACG</a:t>
            </a:r>
            <a:r>
              <a:rPr lang="en-US" sz="750" dirty="0">
                <a:highlight>
                  <a:srgbClr val="FFFF0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GG</a:t>
            </a: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GSG_10313_Down_RScrRNA_1: </a:t>
            </a:r>
            <a:r>
              <a:rPr lang="en-US" sz="750" dirty="0">
                <a:solidFill>
                  <a:srgbClr val="000000"/>
                </a:solidFill>
                <a:highlight>
                  <a:srgbClr val="00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TCCCTATTTCCAGTGCCTT</a:t>
            </a:r>
            <a:r>
              <a:rPr lang="en-US" sz="750" dirty="0">
                <a:highlight>
                  <a:srgbClr val="00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GG</a:t>
            </a: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75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SG_10313IntF1: </a:t>
            </a:r>
            <a:r>
              <a:rPr lang="en-US" sz="750" dirty="0">
                <a:solidFill>
                  <a:srgbClr val="222222"/>
                </a:solidFill>
                <a:highlight>
                  <a:srgbClr val="A9A9A9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TGTGGCTGTGGGATGACTT</a:t>
            </a:r>
            <a:endParaRPr lang="en-CA" sz="75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750" dirty="0">
                <a:solidFill>
                  <a:srgbClr val="222222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GSG_10313IntR1: </a:t>
            </a:r>
            <a:r>
              <a:rPr lang="en-US" sz="750" dirty="0">
                <a:solidFill>
                  <a:srgbClr val="222222"/>
                </a:solidFill>
                <a:highlight>
                  <a:srgbClr val="C0C0C0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CCAGGCCTCCCTGAAGAT</a:t>
            </a:r>
          </a:p>
          <a:p>
            <a:pPr>
              <a:lnSpc>
                <a:spcPct val="107000"/>
              </a:lnSpc>
              <a:spcAft>
                <a:spcPts val="600"/>
              </a:spcAft>
            </a:pPr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crohomology Primer FOR: FGSG_10313_Up_RScrRNA_1</a:t>
            </a:r>
            <a:endParaRPr lang="en-CA" sz="75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CCTGTTTCATCTCATCTCTATATCCCTCTTACCTACAACTCTCTGCATC</a:t>
            </a:r>
            <a:r>
              <a:rPr lang="en-US" sz="750" dirty="0">
                <a:solidFill>
                  <a:srgbClr val="FF0000"/>
                </a:solidFill>
                <a:highlight>
                  <a:srgbClr val="D3D3D3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cgacagaagatgatattga</a:t>
            </a:r>
          </a:p>
          <a:p>
            <a:endParaRPr lang="en-US" sz="750" dirty="0">
              <a:solidFill>
                <a:srgbClr val="FF0000"/>
              </a:solidFill>
              <a:highlight>
                <a:srgbClr val="D3D3D3"/>
              </a:highlight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icrohomology Primer FOR: FGSG_10313_Down_RScrRNA_1</a:t>
            </a:r>
            <a:endParaRPr lang="en-CA" sz="75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750" dirty="0">
              <a:solidFill>
                <a:srgbClr val="000000"/>
              </a:solidFill>
              <a:highlight>
                <a:srgbClr val="A9A9A9"/>
              </a:highlight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r>
              <a:rPr lang="en-US" sz="750" dirty="0">
                <a:solidFill>
                  <a:srgbClr val="000000"/>
                </a:solidFill>
                <a:highlight>
                  <a:srgbClr val="A9A9A9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TCTTGACGAGTTCTTCTGA</a:t>
            </a:r>
            <a:r>
              <a:rPr lang="en-US" sz="750" b="1" dirty="0">
                <a:solidFill>
                  <a:srgbClr val="000000"/>
                </a:solidFill>
                <a:highlight>
                  <a:srgbClr val="00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CCA</a:t>
            </a:r>
            <a:r>
              <a:rPr lang="en-US" sz="750" dirty="0">
                <a:solidFill>
                  <a:srgbClr val="000000"/>
                </a:solidFill>
                <a:highlight>
                  <a:srgbClr val="00FFFF"/>
                </a:highlight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GGCACTGGAAATAGGGAC</a:t>
            </a:r>
            <a:r>
              <a:rPr lang="en-US" sz="7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ATGCTAGGTGGGTTTCGAGTATTTAA</a:t>
            </a:r>
            <a:endParaRPr lang="en-CA" sz="750" dirty="0">
              <a:highlight>
                <a:srgbClr val="C0C0C0"/>
              </a:highlight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endParaRPr lang="en-CA" sz="75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</a:pPr>
            <a:endParaRPr lang="en-CA" sz="75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CA" sz="135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88E57C8-88BC-1E68-2865-150358924E4C}"/>
              </a:ext>
            </a:extLst>
          </p:cNvPr>
          <p:cNvSpPr txBox="1"/>
          <p:nvPr/>
        </p:nvSpPr>
        <p:spPr>
          <a:xfrm>
            <a:off x="1592826" y="5679136"/>
            <a:ext cx="5832987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: The region of insertion of hygromycin in the coding region of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MGV1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F. graminearum. 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3559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0ACA785-31F4-0AE0-00B4-C5319CAE8B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0312" y="476717"/>
            <a:ext cx="4151201" cy="259584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B07E7B0-C303-BA07-5259-1350361A7E8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9959" r="67528"/>
          <a:stretch/>
        </p:blipFill>
        <p:spPr>
          <a:xfrm>
            <a:off x="3536478" y="3072558"/>
            <a:ext cx="1612837" cy="47566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6750C37-B582-EAF5-51C7-9301B1B3C8D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0365"/>
          <a:stretch/>
        </p:blipFill>
        <p:spPr>
          <a:xfrm>
            <a:off x="2430312" y="3663145"/>
            <a:ext cx="4151200" cy="139000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2137F72-5EE3-6A1E-144D-88D89AD324DF}"/>
              </a:ext>
            </a:extLst>
          </p:cNvPr>
          <p:cNvSpPr txBox="1"/>
          <p:nvPr/>
        </p:nvSpPr>
        <p:spPr>
          <a:xfrm>
            <a:off x="2286000" y="5370243"/>
            <a:ext cx="45720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: The region of insertion of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promoter in the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TRI6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promoter  in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F. graminearum. 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3598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192A76-A8AD-BE53-B961-0A8966E7AA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7827" y="351623"/>
            <a:ext cx="4368346" cy="28602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CEBBAD2-27C2-91BD-0C6E-E8380F2ACF00}"/>
              </a:ext>
            </a:extLst>
          </p:cNvPr>
          <p:cNvSpPr txBox="1"/>
          <p:nvPr/>
        </p:nvSpPr>
        <p:spPr>
          <a:xfrm>
            <a:off x="1998742" y="5184957"/>
            <a:ext cx="567812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. Confirmation of ∆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mgv1/TRI6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OX </a:t>
            </a:r>
            <a:r>
              <a:rPr lang="en-CA" sz="1000" i="1" dirty="0">
                <a:latin typeface="Arial" panose="020B0604020202020204" pitchFamily="34" charset="0"/>
                <a:cs typeface="Arial" panose="020B0604020202020204" pitchFamily="34" charset="0"/>
              </a:rPr>
              <a:t>F. graminearum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strain by whole genome sequencing. </a:t>
            </a:r>
            <a:endParaRPr lang="en-CA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134624-DB7A-39D7-B3A2-1456EF12F917}"/>
              </a:ext>
            </a:extLst>
          </p:cNvPr>
          <p:cNvSpPr txBox="1"/>
          <p:nvPr/>
        </p:nvSpPr>
        <p:spPr>
          <a:xfrm>
            <a:off x="1998742" y="22081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67307D-8F29-53BF-B225-E2176EE6A6AF}"/>
              </a:ext>
            </a:extLst>
          </p:cNvPr>
          <p:cNvSpPr txBox="1"/>
          <p:nvPr/>
        </p:nvSpPr>
        <p:spPr>
          <a:xfrm>
            <a:off x="2026827" y="329819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A4B9F78-AB0F-0FC4-509E-F9BF36FC67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61571" y="3328076"/>
            <a:ext cx="4368346" cy="1740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74440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2D43477-A502-7CA8-E3CB-7A25309063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6943" y="678537"/>
            <a:ext cx="6210113" cy="46239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DED8452-7406-DA5C-8B9A-8B7E30BA40F1}"/>
              </a:ext>
            </a:extLst>
          </p:cNvPr>
          <p:cNvSpPr txBox="1"/>
          <p:nvPr/>
        </p:nvSpPr>
        <p:spPr>
          <a:xfrm>
            <a:off x="1659464" y="5452887"/>
            <a:ext cx="553775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0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CA" sz="10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RT-qPCR confirmation of </a:t>
            </a:r>
            <a:r>
              <a:rPr lang="en-CA" sz="10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GV1</a:t>
            </a:r>
            <a:r>
              <a:rPr lang="en-CA" sz="10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CA" sz="10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I6</a:t>
            </a:r>
            <a:r>
              <a:rPr lang="en-CA" sz="10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xpression in the </a:t>
            </a:r>
            <a:r>
              <a:rPr lang="en-CA" sz="10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∆mgv1::TRI6 </a:t>
            </a:r>
            <a:r>
              <a:rPr lang="en-CA" sz="10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trains. </a:t>
            </a:r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58371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094764" y="5264774"/>
            <a:ext cx="4519888" cy="2542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780"/>
              </a:spcAft>
            </a:pPr>
            <a:r>
              <a:rPr lang="en-CA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5.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wth properties of WT 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. graminearum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GV1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ex</a:t>
            </a:r>
            <a:r>
              <a:rPr lang="en-CA" sz="10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CA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rains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AA972CB-9B4E-CCA7-6E0A-37618C2B854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528" r="4920" b="5705"/>
          <a:stretch/>
        </p:blipFill>
        <p:spPr>
          <a:xfrm>
            <a:off x="1147804" y="777461"/>
            <a:ext cx="2861038" cy="1836935"/>
          </a:xfrm>
          <a:prstGeom prst="rect">
            <a:avLst/>
          </a:prstGeom>
        </p:spPr>
      </p:pic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0353275"/>
              </p:ext>
            </p:extLst>
          </p:nvPr>
        </p:nvGraphicFramePr>
        <p:xfrm>
          <a:off x="543026" y="2817923"/>
          <a:ext cx="4070594" cy="2193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626C16B3-0AD6-26DC-E39E-0A1850F312F0}"/>
              </a:ext>
            </a:extLst>
          </p:cNvPr>
          <p:cNvSpPr txBox="1"/>
          <p:nvPr/>
        </p:nvSpPr>
        <p:spPr>
          <a:xfrm>
            <a:off x="477062" y="216979"/>
            <a:ext cx="17247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. Vegetative Growth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D357239-1188-A441-13F9-6C6CE5054C6B}"/>
              </a:ext>
            </a:extLst>
          </p:cNvPr>
          <p:cNvSpPr txBox="1"/>
          <p:nvPr/>
        </p:nvSpPr>
        <p:spPr>
          <a:xfrm>
            <a:off x="4718725" y="216979"/>
            <a:ext cx="22990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. Macroconidia germinatio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/>
        </p:nvGraphicFramePr>
        <p:xfrm>
          <a:off x="4708280" y="755736"/>
          <a:ext cx="4070594" cy="2339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/>
          </p:cNvGraphicFramePr>
          <p:nvPr/>
        </p:nvGraphicFramePr>
        <p:xfrm>
          <a:off x="4709037" y="2836221"/>
          <a:ext cx="4069080" cy="23408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75F5545-19F6-017C-4E1C-4C705E087ED5}"/>
              </a:ext>
            </a:extLst>
          </p:cNvPr>
          <p:cNvSpPr txBox="1"/>
          <p:nvPr/>
        </p:nvSpPr>
        <p:spPr>
          <a:xfrm>
            <a:off x="8114764" y="1847928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1</a:t>
            </a:r>
            <a:endParaRPr lang="en-US"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6005261-942C-C039-98E1-4FA15000D7D6}"/>
              </a:ext>
            </a:extLst>
          </p:cNvPr>
          <p:cNvSpPr txBox="1"/>
          <p:nvPr/>
        </p:nvSpPr>
        <p:spPr>
          <a:xfrm>
            <a:off x="8114764" y="2070836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2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8A84EB-3DA0-550F-A304-F8127F81EC35}"/>
              </a:ext>
            </a:extLst>
          </p:cNvPr>
          <p:cNvSpPr txBox="1"/>
          <p:nvPr/>
        </p:nvSpPr>
        <p:spPr>
          <a:xfrm>
            <a:off x="8114764" y="3928102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6</a:t>
            </a:r>
            <a:endParaRPr lang="en-US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AFB3456-4AB4-75E5-4C8D-F6D35D92610C}"/>
              </a:ext>
            </a:extLst>
          </p:cNvPr>
          <p:cNvSpPr txBox="1"/>
          <p:nvPr/>
        </p:nvSpPr>
        <p:spPr>
          <a:xfrm>
            <a:off x="8114764" y="4151010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8</a:t>
            </a:r>
            <a:endParaRPr lang="en-US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E2C94E-8D3C-8AA7-B2EF-54F1EC6731CE}"/>
              </a:ext>
            </a:extLst>
          </p:cNvPr>
          <p:cNvSpPr txBox="1"/>
          <p:nvPr/>
        </p:nvSpPr>
        <p:spPr>
          <a:xfrm>
            <a:off x="3991795" y="3342201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1</a:t>
            </a:r>
            <a:endParaRPr lang="en-US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31A28F-A00D-42B8-4550-A7BEB71DC9FF}"/>
              </a:ext>
            </a:extLst>
          </p:cNvPr>
          <p:cNvSpPr txBox="1"/>
          <p:nvPr/>
        </p:nvSpPr>
        <p:spPr>
          <a:xfrm>
            <a:off x="3991795" y="3509057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2</a:t>
            </a:r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63B07C-608F-1017-F8B6-760A48F4C965}"/>
              </a:ext>
            </a:extLst>
          </p:cNvPr>
          <p:cNvSpPr txBox="1"/>
          <p:nvPr/>
        </p:nvSpPr>
        <p:spPr>
          <a:xfrm>
            <a:off x="3991795" y="3675913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6</a:t>
            </a:r>
            <a:endParaRPr lang="en-US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702B05-6AD9-25F8-B614-58C3ECC08DC1}"/>
              </a:ext>
            </a:extLst>
          </p:cNvPr>
          <p:cNvSpPr txBox="1"/>
          <p:nvPr/>
        </p:nvSpPr>
        <p:spPr>
          <a:xfrm>
            <a:off x="3991795" y="3842769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8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5524384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32CD74B5-3008-F1B0-121C-D55D19615EBF}"/>
              </a:ext>
            </a:extLst>
          </p:cNvPr>
          <p:cNvSpPr/>
          <p:nvPr/>
        </p:nvSpPr>
        <p:spPr>
          <a:xfrm>
            <a:off x="1494765" y="4815993"/>
            <a:ext cx="6255138" cy="2866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780"/>
              </a:spcAft>
            </a:pPr>
            <a:r>
              <a:rPr lang="en-CA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6. </a:t>
            </a:r>
            <a:r>
              <a:rPr lang="en-CA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-ADON accumulation in </a:t>
            </a:r>
            <a:r>
              <a:rPr lang="el-GR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</a:t>
            </a:r>
            <a:r>
              <a:rPr lang="en-CA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v1</a:t>
            </a:r>
            <a:r>
              <a:rPr lang="en-CA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CA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GV1</a:t>
            </a:r>
            <a:r>
              <a:rPr lang="en-CA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ex strains compared with WT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18A71AC4-2882-1A21-A950-66D6338CA7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506518"/>
              </p:ext>
            </p:extLst>
          </p:nvPr>
        </p:nvGraphicFramePr>
        <p:xfrm>
          <a:off x="1845447" y="1317217"/>
          <a:ext cx="5117415" cy="31563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60BBFAA8-A84C-E207-0274-E086898A829B}"/>
              </a:ext>
            </a:extLst>
          </p:cNvPr>
          <p:cNvSpPr txBox="1"/>
          <p:nvPr/>
        </p:nvSpPr>
        <p:spPr>
          <a:xfrm>
            <a:off x="4029223" y="3979823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1</a:t>
            </a:r>
            <a:endParaRPr 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36BB41-8175-36CE-933D-BA0CE880DB41}"/>
              </a:ext>
            </a:extLst>
          </p:cNvPr>
          <p:cNvSpPr txBox="1"/>
          <p:nvPr/>
        </p:nvSpPr>
        <p:spPr>
          <a:xfrm>
            <a:off x="4750677" y="3979823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2</a:t>
            </a:r>
            <a:endParaRPr lang="en-US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E86F13D-7847-6168-AEBC-31FD017941C5}"/>
              </a:ext>
            </a:extLst>
          </p:cNvPr>
          <p:cNvSpPr txBox="1"/>
          <p:nvPr/>
        </p:nvSpPr>
        <p:spPr>
          <a:xfrm>
            <a:off x="5463742" y="3979823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6</a:t>
            </a:r>
            <a:endParaRPr lang="en-US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6070B45-92BE-D714-A96E-91BD8E971E36}"/>
              </a:ext>
            </a:extLst>
          </p:cNvPr>
          <p:cNvSpPr txBox="1"/>
          <p:nvPr/>
        </p:nvSpPr>
        <p:spPr>
          <a:xfrm>
            <a:off x="6185196" y="3979823"/>
            <a:ext cx="593111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n-CA" sz="1000" i="1" dirty="0"/>
              <a:t>MGV1</a:t>
            </a:r>
            <a:r>
              <a:rPr lang="en-CA" sz="1000" dirty="0"/>
              <a:t>Oex8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7EF5B5-DE16-A512-EFB4-B709DB8BC412}"/>
              </a:ext>
            </a:extLst>
          </p:cNvPr>
          <p:cNvSpPr txBox="1"/>
          <p:nvPr/>
        </p:nvSpPr>
        <p:spPr>
          <a:xfrm>
            <a:off x="3425828" y="3979823"/>
            <a:ext cx="362279" cy="153888"/>
          </a:xfrm>
          <a:prstGeom prst="rect">
            <a:avLst/>
          </a:prstGeom>
          <a:solidFill>
            <a:schemeClr val="bg1"/>
          </a:solidFill>
        </p:spPr>
        <p:txBody>
          <a:bodyPr wrap="none" lIns="0" tIns="0" rIns="0" bIns="0" rtlCol="0">
            <a:spAutoFit/>
          </a:bodyPr>
          <a:lstStyle/>
          <a:p>
            <a:r>
              <a:rPr lang="el-GR" sz="1000" dirty="0"/>
              <a:t>Δ</a:t>
            </a:r>
            <a:r>
              <a:rPr lang="en-CA" sz="1000" i="1" dirty="0"/>
              <a:t>mgv1</a:t>
            </a:r>
            <a:endParaRPr lang="en-US" sz="1000" i="1" dirty="0"/>
          </a:p>
        </p:txBody>
      </p:sp>
    </p:spTree>
    <p:extLst>
      <p:ext uri="{BB962C8B-B14F-4D97-AF65-F5344CB8AC3E}">
        <p14:creationId xmlns:p14="http://schemas.microsoft.com/office/powerpoint/2010/main" val="37921138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8693E78E-269C-34BD-A781-A870BDC96D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39690194"/>
              </p:ext>
            </p:extLst>
          </p:nvPr>
        </p:nvGraphicFramePr>
        <p:xfrm>
          <a:off x="287604" y="1046815"/>
          <a:ext cx="4057894" cy="3357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8A5B0E6C-2685-4E8D-E4CD-44AA06E53A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1809535"/>
              </p:ext>
            </p:extLst>
          </p:nvPr>
        </p:nvGraphicFramePr>
        <p:xfrm>
          <a:off x="4345498" y="1046815"/>
          <a:ext cx="4689446" cy="33574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F0F3E49E-932B-0F9B-2F87-B33FB1F37182}"/>
              </a:ext>
            </a:extLst>
          </p:cNvPr>
          <p:cNvSpPr/>
          <p:nvPr/>
        </p:nvSpPr>
        <p:spPr>
          <a:xfrm>
            <a:off x="2041350" y="4686598"/>
            <a:ext cx="5061299" cy="2704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780"/>
              </a:spcAft>
            </a:pPr>
            <a:r>
              <a:rPr lang="en-CA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7. </a:t>
            </a:r>
            <a:r>
              <a:rPr lang="en-CA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HB disease assays in wheat cultivars A. Roblin and B. Penhold. 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AA7FD8-ABE5-106E-6534-672C6D26AA7B}"/>
              </a:ext>
            </a:extLst>
          </p:cNvPr>
          <p:cNvSpPr txBox="1"/>
          <p:nvPr/>
        </p:nvSpPr>
        <p:spPr>
          <a:xfrm>
            <a:off x="477062" y="216979"/>
            <a:ext cx="8627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A. Robl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7ED685-3FEB-1BC9-61EC-FE502F00932F}"/>
              </a:ext>
            </a:extLst>
          </p:cNvPr>
          <p:cNvSpPr txBox="1"/>
          <p:nvPr/>
        </p:nvSpPr>
        <p:spPr>
          <a:xfrm>
            <a:off x="4718725" y="216979"/>
            <a:ext cx="10342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>
                <a:latin typeface="Arial" panose="020B0604020202020204" pitchFamily="34" charset="0"/>
                <a:cs typeface="Arial" panose="020B0604020202020204" pitchFamily="34" charset="0"/>
              </a:rPr>
              <a:t>B. Penhold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39098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B7A145D-1901-FC70-8381-FDAB6FD3C8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9639" y="914400"/>
            <a:ext cx="3393186" cy="328662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E4A4A0D-0017-7207-34F3-0995C085F8A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577"/>
          <a:stretch/>
        </p:blipFill>
        <p:spPr>
          <a:xfrm>
            <a:off x="4309273" y="993245"/>
            <a:ext cx="3292113" cy="31703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6F73E55-8468-4100-0D79-8D6E354B9A68}"/>
              </a:ext>
            </a:extLst>
          </p:cNvPr>
          <p:cNvSpPr txBox="1"/>
          <p:nvPr/>
        </p:nvSpPr>
        <p:spPr>
          <a:xfrm>
            <a:off x="583034" y="5025524"/>
            <a:ext cx="832499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8. 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onstitutive expression of </a:t>
            </a:r>
            <a:r>
              <a:rPr lang="en-CA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RI</a:t>
            </a:r>
            <a:r>
              <a:rPr lang="en-CA" sz="1200" i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ffects does not phenocopy MGV1-dependent fitness of </a:t>
            </a:r>
            <a:r>
              <a:rPr lang="en-CA" sz="1200" i="1" dirty="0">
                <a:latin typeface="Arial" panose="020B0604020202020204" pitchFamily="34" charset="0"/>
                <a:cs typeface="Arial" panose="020B0604020202020204" pitchFamily="34" charset="0"/>
              </a:rPr>
              <a:t>F. graminearum.</a:t>
            </a:r>
            <a:r>
              <a:rPr lang="en-CA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CA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011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37</TotalTime>
  <Words>278</Words>
  <Application>Microsoft Office PowerPoint</Application>
  <PresentationFormat>Letter Paper (8.5x11 in)</PresentationFormat>
  <Paragraphs>56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bramaniam, Rajagopal (AAFC/AAC)</dc:creator>
  <cp:lastModifiedBy>Subramaniam, Rajagopal (AAFC/AAC)</cp:lastModifiedBy>
  <cp:revision>4</cp:revision>
  <dcterms:created xsi:type="dcterms:W3CDTF">2023-05-14T17:44:14Z</dcterms:created>
  <dcterms:modified xsi:type="dcterms:W3CDTF">2023-08-01T14:00:57Z</dcterms:modified>
</cp:coreProperties>
</file>